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8" r:id="rId2"/>
    <p:sldId id="280" r:id="rId3"/>
    <p:sldId id="263" r:id="rId4"/>
    <p:sldId id="282" r:id="rId5"/>
    <p:sldId id="259" r:id="rId6"/>
    <p:sldId id="279" r:id="rId7"/>
    <p:sldId id="261" r:id="rId8"/>
    <p:sldId id="262" r:id="rId9"/>
    <p:sldId id="281" r:id="rId10"/>
    <p:sldId id="283" r:id="rId1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72" autoAdjust="0"/>
    <p:restoredTop sz="73207" autoAdjust="0"/>
  </p:normalViewPr>
  <p:slideViewPr>
    <p:cSldViewPr snapToGrid="0">
      <p:cViewPr varScale="1">
        <p:scale>
          <a:sx n="49" d="100"/>
          <a:sy n="49" d="100"/>
        </p:scale>
        <p:origin x="1340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C50FAE-918B-4F24-B1A3-4FEEDB85CA43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C9C6D3-B610-4F61-B489-B027CC2156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972007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dirty="0"/>
              <a:t>Supplement Figure</a:t>
            </a:r>
            <a:r>
              <a:rPr lang="en-US" altLang="zh-CN" sz="18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1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Epitope, sequence diversity, and specificity of anti-CD38 antibodies. (A) Epitope binning of anti-CD38 antibodies; the epitopes were clustered into four categories. (B) and (C) Homology analysis of the light and heavy-chain amino acid sequences of antibodies. The results showed that the sequence homology was relatively low, especially for the heavy chain, indicating a high diversity of anti-CD38 antibodies. (D) Homology analysis of the light and heavy chain amino acid sequences of anti-CD38 antibodies. The results indicated that the sequence homology of both chains was relatively low, especially for the heavy chain (≤75%), indicating a high diversity of anti-CD38 antibodies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4043891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zh-CN" sz="1800" b="1" i="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Supplementary Figure 10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D38/CD47 BsAbs exhibited ADCC against Raji using primary PBMC as effector cells.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Except for 26B4, which had a lower activity than the other BsAbs, the difference in activity between the other BsAbs </a:t>
            </a:r>
            <a:r>
              <a:rPr lang="en-US" altLang="zh-CN" sz="180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was 1-2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times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611558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Supplementary Figure 3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Flow cytometry analysis of CD38 expression in various cancer cell lines. Cancer cells were stained with 10 μg/mL mouse IgG1, the anti-CD38 antibody 26B4 (filled histogram), or mouse IgG1, an isotype control (open histogram)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428982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Supplementary Figure 3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The affinity of the anti-CD38 antibodies was measured by BLI. The results showed that the calculated KD values of all the anti-CD38 antibodies (except for 65A7) that bound to purified human CD38 were lower than the KD values of daratumumab and isatuximab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/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35840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E9F3B79-6A6D-457D-5C09-78C67F71B21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>
            <a:extLst>
              <a:ext uri="{FF2B5EF4-FFF2-40B4-BE49-F238E27FC236}">
                <a16:creationId xmlns:a16="http://schemas.microsoft.com/office/drawing/2014/main" id="{7B7E3F00-307A-DB0F-7CC6-33CC9E7EBD36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>
            <a:extLst>
              <a:ext uri="{FF2B5EF4-FFF2-40B4-BE49-F238E27FC236}">
                <a16:creationId xmlns:a16="http://schemas.microsoft.com/office/drawing/2014/main" id="{CFF10470-DD48-F286-F7AB-233AC3CCD4C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dirty="0"/>
              <a:t>Supplement Figure</a:t>
            </a:r>
            <a:r>
              <a:rPr lang="en-US" altLang="zh-CN" sz="180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4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(A) Binding of anti-CD38 antibodies to human CD38-overexpressing CHO cells. The results revealed that the anti-CD38 antibodies specifically bound CHO-CD38 cells in a concentration-dependent manner. (B) Binding of anti-CD38 antibodies to CD38-negative CHO cells. The results showed that anti-CD38 antibodies did not bind to CHO cells. (C) Binding of anti-CD38 antibodies to cynomolgus CD38-overexpressing CHO cells. The results showed that 65A7, 12C10, 32D6, 82G10, 4A8, and 16C2 cross-reacted with cynomolgus CD38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AD990E7-A28D-E9E7-B81E-A69E3B90AE86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03676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Supplementary Figure 5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CD38 antibodies bind to hematologic cancer cell lines in a concentration-dependent manner. (A) and (B) Anti-CD38 antibodies bound to non-Hodgkin's lymphoma cells (Raji and Daudi). (C) Anti-CD38 antibodies bound to multiple myeloma cells (NCI-H929). (D) Anti-CD38 antibodies bound to Hodgkin's lymphoma cells (L-1236). (E) Anti-CD38 antibodies bound to acute lymphocytic leukemia cells (Reh). (F) Anti-CD38 antibodies bound to acute myeloid leukemia cells (MOLM-13)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475909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Supplementary Figure 6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Anti-CD38 antibody-induced RBC agglutination and binding analysis. (A) Anti-CD38 antibodies bound to RBCs, as determined by flow cytometry assays. (B) Anti-CD38 antibodies induced RBC agglutination. (C) Anti-CD38 antibodies bound to platelets, as determined by flow cytometry assays. Unlike the CD47 antibody Hu5F9, even at a concentration of 100 nM, the anti-CD38 antibodies did not bind to RBCs or platelets and did not induce RBC agglutination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48393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just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Supplementary Figure 7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The purity of the anti-CD38 antibodies was evaluated by HPLC-SEC (A) and SDS‒PAGE (B), and the results showed that the purity was greater than 90%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317708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zh-CN" sz="1800" b="1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Supplementary Figure 8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affinity of CD38/CD47 BsAbs for CD38 was measured by BLI. The results showed that the calculated KD values of all CD38/CD47 BsAbs (except for 65A7) that bound to purified human CD38 were greater than the KD values of IMM5605-ISA (based on isatuximab) and IMM5605-DARA (based on daratumumab)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134287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zh-CN" sz="1800" b="1" i="0" kern="100" dirty="0">
                <a:effectLst/>
                <a:latin typeface="等线" panose="02010600030101010101" pitchFamily="2" charset="-122"/>
                <a:ea typeface="等线" panose="02010600030101010101" pitchFamily="2" charset="-122"/>
                <a:cs typeface="Arial" panose="020B0604020202020204" pitchFamily="34" charset="0"/>
              </a:rPr>
              <a:t>Supplementary Figure 9.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affinity of CD38/CD47 BsAbs for CD47 was measured by BLI. The results showed that the calculated KD value of the CD38/CD47 BsAbs that bound to purified human CD47 was similar to that of IMM01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4C9C6D3-B610-4F61-B489-B027CC215666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08936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1F4E74A-0989-F0C8-02F1-AA08C0FEB4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49AA2EB4-F307-BCB6-CAF4-18F8B0A887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3A49B10-8CF3-C6F7-C4CC-5476EF0FF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FCD59CB-47A5-E676-A5ED-777A722E6B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7E290EF-2D49-7D7D-DFE6-EEAFE54BC3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0927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6CC4107-1278-A3CC-4F8D-2D7FB39DA5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0C821F9-F413-85D4-9438-439EEDC8800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AB550B-7AE8-3A60-3359-FB507A872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28150F-C20C-BC34-B86C-9A85F45ACF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41646EC-D8E5-FBC2-7E1A-F13F2BB85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905982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5DE102F-5E5B-0FAA-C204-6E8B008E0F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6A14341-B3A5-F4B4-A7E8-6A183AEB954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7A1EDEC-6929-C28C-167C-188F1C01D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93C90C-F942-7802-415D-4C6D5BA53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B75D3F-945E-C402-DB75-2D735A608B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90408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4D2A0B-D706-41E9-3FD7-D6440E97C7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628282-5C52-176B-7966-9F9E1E4DB4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DE02CA-2E2A-1B9B-1E6E-0ABB85266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855DA19-7796-BA8A-DFF4-4FEDF45F3B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B34F57F-C2CF-86BA-312D-B9A4B515D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14525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EFAE43-2289-FC6B-3F71-1903634F3C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85CB44B-9BBB-01CC-606C-E979A1A786A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AD0E00-B0FE-AECF-C571-C9BF01D295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50D539-6970-4F7D-D731-4C0A41E8A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DBC191C-958D-D586-2AB9-B3F97B4220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5984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C8BA60E-B0CE-C3D4-6401-90C5E968D7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AC45E2E-8501-5793-78AF-B532B4DC9BF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C41DAB0-5277-2F38-21D9-A47FDECB6F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630B760-D094-3B27-00A5-D88259FAC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56B7C19-DCCB-C286-80F5-8DA94B529B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C3539C4-8BAE-25D9-799F-F7684C09C1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0505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53043C-2239-EF8A-7D02-9FC5408946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9F299CB-6B96-BA11-B5BC-3A83352DB7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A87FDCB-7788-A86F-8560-BCCDDC9410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82FCCAB-1360-EF28-1728-D376A41AA3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5BDDC53-B3A4-8E16-8EFE-672ADB9DE6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28E8EA6-984F-6C29-FF80-FCBA2A70DB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3668A4D-AD89-E84F-F1CC-55B486FBF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442DEF18-CFA1-9B74-26DE-2714BB79A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88002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9447251-AD1B-3635-FF8F-BBF500FFF2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68C782F-7C00-240B-4836-3B8A4A753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98677E-B83F-69BA-ABF2-E54951F74B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FCEFA73-8BF2-E5C3-846E-3F4D610EF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569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0CDC86C-ED15-103A-CB0A-0257BE317F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976AB27-D99F-B1E1-F799-1D8CF246EF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18DB783-132B-5584-4AFD-0AD4A77110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3782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BB0DB5-7D61-78F1-A0DA-ED369EB251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5EF45D22-A04D-B2EC-C200-A0D06AE02F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0818A1A-CAD4-CB95-1AF4-F1D0879483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4F1520-8451-5939-4CAE-D03A0EC335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98142B-B649-8E0D-A538-0EB608BBD4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16B99BE-B697-C613-DC32-AB24ABB248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7023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31629E4-EB94-9973-04F4-416FEFDCDE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E2FAF00-5749-F92B-018B-EA7C04015B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C3BFBAC-067A-2939-AADB-80393580E5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28EE77F-11DA-C0B7-2952-30134252F1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11A73DB-8E57-50B8-1F9D-71671D26A7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6ACEA2F-139C-62A6-AA51-411975F220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94909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C57F2B1-80C5-422E-468D-F2973F2604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7C6126-904E-18E2-84B7-699E6FAAAF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0321709-F49A-CFD3-A64C-66AEE947CB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3CFA4-39EC-4C06-893F-0C0B8364116E}" type="datetimeFigureOut">
              <a:rPr lang="zh-CN" altLang="en-US" smtClean="0"/>
              <a:t>2024/4/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111422-8544-1235-C525-A6B52663D9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C0A58B5-94E4-79B5-A210-43C2873472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36F854-405F-4B8D-A4FA-A0F96736CD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37652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9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68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image" Target="../media/image14.emf"/><Relationship Id="rId18" Type="http://schemas.openxmlformats.org/officeDocument/2006/relationships/image" Target="../media/image1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12" Type="http://schemas.openxmlformats.org/officeDocument/2006/relationships/image" Target="../media/image13.emf"/><Relationship Id="rId17" Type="http://schemas.openxmlformats.org/officeDocument/2006/relationships/image" Target="../media/image18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7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.emf"/><Relationship Id="rId11" Type="http://schemas.openxmlformats.org/officeDocument/2006/relationships/image" Target="../media/image12.emf"/><Relationship Id="rId5" Type="http://schemas.openxmlformats.org/officeDocument/2006/relationships/image" Target="../media/image6.emf"/><Relationship Id="rId15" Type="http://schemas.openxmlformats.org/officeDocument/2006/relationships/image" Target="../media/image16.emf"/><Relationship Id="rId10" Type="http://schemas.openxmlformats.org/officeDocument/2006/relationships/image" Target="../media/image11.emf"/><Relationship Id="rId4" Type="http://schemas.openxmlformats.org/officeDocument/2006/relationships/image" Target="../media/image5.emf"/><Relationship Id="rId9" Type="http://schemas.openxmlformats.org/officeDocument/2006/relationships/image" Target="../media/image10.emf"/><Relationship Id="rId14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3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2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emf"/><Relationship Id="rId13" Type="http://schemas.openxmlformats.org/officeDocument/2006/relationships/oleObject" Target="../embeddings/oleObject9.bin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12" Type="http://schemas.openxmlformats.org/officeDocument/2006/relationships/image" Target="../media/image39.emf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6.emf"/><Relationship Id="rId11" Type="http://schemas.openxmlformats.org/officeDocument/2006/relationships/oleObject" Target="../embeddings/oleObject8.bin"/><Relationship Id="rId5" Type="http://schemas.openxmlformats.org/officeDocument/2006/relationships/oleObject" Target="../embeddings/oleObject5.bin"/><Relationship Id="rId10" Type="http://schemas.openxmlformats.org/officeDocument/2006/relationships/image" Target="../media/image38.emf"/><Relationship Id="rId4" Type="http://schemas.openxmlformats.org/officeDocument/2006/relationships/image" Target="../media/image35.emf"/><Relationship Id="rId9" Type="http://schemas.openxmlformats.org/officeDocument/2006/relationships/oleObject" Target="../embeddings/oleObject7.bin"/><Relationship Id="rId14" Type="http://schemas.openxmlformats.org/officeDocument/2006/relationships/image" Target="../media/image40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7" Type="http://schemas.openxmlformats.org/officeDocument/2006/relationships/image" Target="../media/image43.em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oleObject" Target="../embeddings/oleObject11.bin"/><Relationship Id="rId5" Type="http://schemas.openxmlformats.org/officeDocument/2006/relationships/image" Target="../media/image42.jpeg"/><Relationship Id="rId4" Type="http://schemas.openxmlformats.org/officeDocument/2006/relationships/image" Target="../media/image41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9.png"/><Relationship Id="rId3" Type="http://schemas.openxmlformats.org/officeDocument/2006/relationships/image" Target="../media/image44.png"/><Relationship Id="rId7" Type="http://schemas.openxmlformats.org/officeDocument/2006/relationships/image" Target="../media/image4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png"/><Relationship Id="rId5" Type="http://schemas.openxmlformats.org/officeDocument/2006/relationships/image" Target="../media/image46.png"/><Relationship Id="rId10" Type="http://schemas.openxmlformats.org/officeDocument/2006/relationships/image" Target="../media/image51.jpeg"/><Relationship Id="rId4" Type="http://schemas.openxmlformats.org/officeDocument/2006/relationships/image" Target="../media/image45.png"/><Relationship Id="rId9" Type="http://schemas.openxmlformats.org/officeDocument/2006/relationships/image" Target="../media/image50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7.png"/><Relationship Id="rId3" Type="http://schemas.openxmlformats.org/officeDocument/2006/relationships/image" Target="../media/image52.png"/><Relationship Id="rId7" Type="http://schemas.openxmlformats.org/officeDocument/2006/relationships/image" Target="../media/image56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5.png"/><Relationship Id="rId5" Type="http://schemas.openxmlformats.org/officeDocument/2006/relationships/image" Target="../media/image54.png"/><Relationship Id="rId10" Type="http://schemas.openxmlformats.org/officeDocument/2006/relationships/image" Target="../media/image59.png"/><Relationship Id="rId4" Type="http://schemas.openxmlformats.org/officeDocument/2006/relationships/image" Target="../media/image53.png"/><Relationship Id="rId9" Type="http://schemas.openxmlformats.org/officeDocument/2006/relationships/image" Target="../media/image58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5.png"/><Relationship Id="rId3" Type="http://schemas.openxmlformats.org/officeDocument/2006/relationships/image" Target="../media/image60.png"/><Relationship Id="rId7" Type="http://schemas.openxmlformats.org/officeDocument/2006/relationships/image" Target="../media/image64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3.png"/><Relationship Id="rId5" Type="http://schemas.openxmlformats.org/officeDocument/2006/relationships/image" Target="../media/image62.png"/><Relationship Id="rId10" Type="http://schemas.openxmlformats.org/officeDocument/2006/relationships/image" Target="../media/image67.png"/><Relationship Id="rId4" Type="http://schemas.openxmlformats.org/officeDocument/2006/relationships/image" Target="../media/image61.png"/><Relationship Id="rId9" Type="http://schemas.openxmlformats.org/officeDocument/2006/relationships/image" Target="../media/image6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组合 8">
            <a:extLst>
              <a:ext uri="{FF2B5EF4-FFF2-40B4-BE49-F238E27FC236}">
                <a16:creationId xmlns:a16="http://schemas.microsoft.com/office/drawing/2014/main" id="{E36056FC-2047-1E85-45FD-58E1EE9BA857}"/>
              </a:ext>
            </a:extLst>
          </p:cNvPr>
          <p:cNvGrpSpPr>
            <a:grpSpLocks noChangeAspect="1"/>
          </p:cNvGrpSpPr>
          <p:nvPr/>
        </p:nvGrpSpPr>
        <p:grpSpPr>
          <a:xfrm>
            <a:off x="595898" y="598461"/>
            <a:ext cx="4071511" cy="2880000"/>
            <a:chOff x="595903" y="958060"/>
            <a:chExt cx="3493214" cy="2470940"/>
          </a:xfrm>
        </p:grpSpPr>
        <p:sp>
          <p:nvSpPr>
            <p:cNvPr id="4" name="矩形: 圆角 3">
              <a:extLst>
                <a:ext uri="{FF2B5EF4-FFF2-40B4-BE49-F238E27FC236}">
                  <a16:creationId xmlns:a16="http://schemas.microsoft.com/office/drawing/2014/main" id="{36103F26-CEB5-5ED4-E616-111106D0CE63}"/>
                </a:ext>
              </a:extLst>
            </p:cNvPr>
            <p:cNvSpPr/>
            <p:nvPr/>
          </p:nvSpPr>
          <p:spPr>
            <a:xfrm>
              <a:off x="595903" y="2203805"/>
              <a:ext cx="1150706" cy="122519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solidFill>
                    <a:schemeClr val="tx1"/>
                  </a:solidFill>
                </a:rPr>
                <a:t>65A7, 82G10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5" name="矩形: 圆角 4">
              <a:extLst>
                <a:ext uri="{FF2B5EF4-FFF2-40B4-BE49-F238E27FC236}">
                  <a16:creationId xmlns:a16="http://schemas.microsoft.com/office/drawing/2014/main" id="{F74BCF7E-A4F0-23A1-7230-7B85098AEB8A}"/>
                </a:ext>
              </a:extLst>
            </p:cNvPr>
            <p:cNvSpPr/>
            <p:nvPr/>
          </p:nvSpPr>
          <p:spPr>
            <a:xfrm>
              <a:off x="1767157" y="2203804"/>
              <a:ext cx="1150706" cy="122519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solidFill>
                    <a:schemeClr val="tx1"/>
                  </a:solidFill>
                </a:rPr>
                <a:t>12C10, 32D6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6" name="矩形: 圆角 5">
              <a:extLst>
                <a:ext uri="{FF2B5EF4-FFF2-40B4-BE49-F238E27FC236}">
                  <a16:creationId xmlns:a16="http://schemas.microsoft.com/office/drawing/2014/main" id="{D9B4C47D-CD3F-B354-3B3A-75A6638F057F}"/>
                </a:ext>
              </a:extLst>
            </p:cNvPr>
            <p:cNvSpPr/>
            <p:nvPr/>
          </p:nvSpPr>
          <p:spPr>
            <a:xfrm>
              <a:off x="2938411" y="2203804"/>
              <a:ext cx="1150706" cy="122519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solidFill>
                    <a:schemeClr val="tx1"/>
                  </a:solidFill>
                </a:rPr>
                <a:t>4A8, 16C2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  <p:sp>
          <p:nvSpPr>
            <p:cNvPr id="7" name="矩形: 圆角 6">
              <a:extLst>
                <a:ext uri="{FF2B5EF4-FFF2-40B4-BE49-F238E27FC236}">
                  <a16:creationId xmlns:a16="http://schemas.microsoft.com/office/drawing/2014/main" id="{A7912321-0560-E8F1-A90D-C77BFABA16CA}"/>
                </a:ext>
              </a:extLst>
            </p:cNvPr>
            <p:cNvSpPr/>
            <p:nvPr/>
          </p:nvSpPr>
          <p:spPr>
            <a:xfrm>
              <a:off x="1436672" y="958060"/>
              <a:ext cx="1789414" cy="1225195"/>
            </a:xfrm>
            <a:prstGeom prst="round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dirty="0">
                  <a:solidFill>
                    <a:schemeClr val="tx1"/>
                  </a:solidFill>
                </a:rPr>
                <a:t>35G5, 26B4, 25B5</a:t>
              </a:r>
              <a:endParaRPr lang="zh-CN" altLang="en-US" dirty="0">
                <a:solidFill>
                  <a:schemeClr val="tx1"/>
                </a:solidFill>
              </a:endParaRPr>
            </a:p>
          </p:txBody>
        </p:sp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BA01CCB4-3CEE-B012-977F-73486DC6CF41}"/>
              </a:ext>
            </a:extLst>
          </p:cNvPr>
          <p:cNvSpPr txBox="1"/>
          <p:nvPr/>
        </p:nvSpPr>
        <p:spPr>
          <a:xfrm>
            <a:off x="14725" y="10276"/>
            <a:ext cx="2666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1.</a:t>
            </a:r>
            <a:endParaRPr lang="zh-CN" altLang="en-US" sz="2000" b="1" dirty="0"/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FFB9DA71-99DF-43F1-3BB9-878AE1F6FE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59901" y="598461"/>
            <a:ext cx="2158289" cy="2880000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54C313B-2659-BE38-A7CF-B4D4453E655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71527" y="598461"/>
            <a:ext cx="2260429" cy="2880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083140AA-DB6B-6C23-B9FF-1DE1F8C8A18D}"/>
              </a:ext>
            </a:extLst>
          </p:cNvPr>
          <p:cNvSpPr txBox="1"/>
          <p:nvPr/>
        </p:nvSpPr>
        <p:spPr>
          <a:xfrm>
            <a:off x="595898" y="413795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1A</a:t>
            </a:r>
            <a:endParaRPr lang="zh-CN" altLang="en-US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DEBD2F39-F654-2D9C-B3D5-33D528637156}"/>
              </a:ext>
            </a:extLst>
          </p:cNvPr>
          <p:cNvSpPr txBox="1"/>
          <p:nvPr/>
        </p:nvSpPr>
        <p:spPr>
          <a:xfrm>
            <a:off x="5525697" y="41379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1B</a:t>
            </a:r>
            <a:endParaRPr lang="zh-CN" altLang="en-US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C4CC923-0B8D-5B91-B4EC-B04A5639DB1C}"/>
              </a:ext>
            </a:extLst>
          </p:cNvPr>
          <p:cNvSpPr txBox="1"/>
          <p:nvPr/>
        </p:nvSpPr>
        <p:spPr>
          <a:xfrm>
            <a:off x="8771522" y="413795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1C</a:t>
            </a:r>
            <a:endParaRPr lang="zh-CN" altLang="en-US" b="1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5699CF70-E2C1-FCC2-E240-31F673FC707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184" t="20020" r="1643" b="12343"/>
          <a:stretch/>
        </p:blipFill>
        <p:spPr>
          <a:xfrm>
            <a:off x="595898" y="3877871"/>
            <a:ext cx="7462109" cy="2952000"/>
          </a:xfrm>
          <a:prstGeom prst="rect">
            <a:avLst/>
          </a:prstGeom>
          <a:ln w="15875">
            <a:solidFill>
              <a:schemeClr val="accent1"/>
            </a:solidFill>
          </a:ln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99E46408-CA2A-0088-6AC3-A0A73C0C4DFF}"/>
              </a:ext>
            </a:extLst>
          </p:cNvPr>
          <p:cNvSpPr txBox="1"/>
          <p:nvPr/>
        </p:nvSpPr>
        <p:spPr>
          <a:xfrm>
            <a:off x="595898" y="3543775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1D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9876457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BA01CCB4-3CEE-B012-977F-73486DC6CF41}"/>
              </a:ext>
            </a:extLst>
          </p:cNvPr>
          <p:cNvSpPr txBox="1"/>
          <p:nvPr/>
        </p:nvSpPr>
        <p:spPr>
          <a:xfrm>
            <a:off x="14725" y="10276"/>
            <a:ext cx="280878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10.</a:t>
            </a:r>
            <a:endParaRPr lang="zh-CN" altLang="en-US" sz="2000" b="1" dirty="0"/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213B925F-F7EB-6971-C305-592E9A4F08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0503486"/>
              </p:ext>
            </p:extLst>
          </p:nvPr>
        </p:nvGraphicFramePr>
        <p:xfrm>
          <a:off x="66675" y="723900"/>
          <a:ext cx="5513388" cy="3003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5512958" imgH="3004233" progId="Prism10.Document">
                  <p:embed/>
                </p:oleObj>
              </mc:Choice>
              <mc:Fallback>
                <p:oleObj name="Prism 10" r:id="rId3" imgW="5512958" imgH="300423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6675" y="723900"/>
                        <a:ext cx="5513388" cy="3003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64730557-72A7-0BCF-8920-A128CE9FE6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5359014"/>
              </p:ext>
            </p:extLst>
          </p:nvPr>
        </p:nvGraphicFramePr>
        <p:xfrm>
          <a:off x="5768975" y="723900"/>
          <a:ext cx="5513388" cy="3003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5512958" imgH="3004233" progId="Prism10.Document">
                  <p:embed/>
                </p:oleObj>
              </mc:Choice>
              <mc:Fallback>
                <p:oleObj name="Prism 10" r:id="rId5" imgW="5512958" imgH="300423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68975" y="723900"/>
                        <a:ext cx="5513388" cy="3003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9382378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图片 63">
            <a:extLst>
              <a:ext uri="{FF2B5EF4-FFF2-40B4-BE49-F238E27FC236}">
                <a16:creationId xmlns:a16="http://schemas.microsoft.com/office/drawing/2014/main" id="{00000000-0008-0000-0000-000027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70708" y="3750224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A01CCB4-3CEE-B012-977F-73486DC6CF41}"/>
              </a:ext>
            </a:extLst>
          </p:cNvPr>
          <p:cNvSpPr txBox="1"/>
          <p:nvPr/>
        </p:nvSpPr>
        <p:spPr>
          <a:xfrm>
            <a:off x="14725" y="10276"/>
            <a:ext cx="260359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2</a:t>
            </a:r>
            <a:endParaRPr lang="zh-CN" altLang="en-US" sz="20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13EE984A-6A76-0005-065F-BFBC91419557}"/>
              </a:ext>
            </a:extLst>
          </p:cNvPr>
          <p:cNvSpPr txBox="1"/>
          <p:nvPr/>
        </p:nvSpPr>
        <p:spPr>
          <a:xfrm>
            <a:off x="1622601" y="1167399"/>
            <a:ext cx="5982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Daudi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B1586D7-5BF7-2A1C-EBC5-ECF7FD1C659D}"/>
              </a:ext>
            </a:extLst>
          </p:cNvPr>
          <p:cNvSpPr txBox="1"/>
          <p:nvPr/>
        </p:nvSpPr>
        <p:spPr>
          <a:xfrm>
            <a:off x="1622600" y="2559392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Raji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D42876F-0C91-FE46-4726-2AF83D18CDA3}"/>
              </a:ext>
            </a:extLst>
          </p:cNvPr>
          <p:cNvSpPr txBox="1"/>
          <p:nvPr/>
        </p:nvSpPr>
        <p:spPr>
          <a:xfrm>
            <a:off x="1622600" y="4024952"/>
            <a:ext cx="4523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Reh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8AB2A95-B1B0-6ECD-2764-AC282E2AF23E}"/>
              </a:ext>
            </a:extLst>
          </p:cNvPr>
          <p:cNvSpPr txBox="1"/>
          <p:nvPr/>
        </p:nvSpPr>
        <p:spPr>
          <a:xfrm>
            <a:off x="1622599" y="5447767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L-1236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ADA81AC-80BE-DAC6-D615-C1300C6F4F3B}"/>
              </a:ext>
            </a:extLst>
          </p:cNvPr>
          <p:cNvSpPr txBox="1"/>
          <p:nvPr/>
        </p:nvSpPr>
        <p:spPr>
          <a:xfrm>
            <a:off x="3336322" y="1167399"/>
            <a:ext cx="8899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NCI-H929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51351FB-5EE2-17D7-FF29-42061D5BCCCE}"/>
              </a:ext>
            </a:extLst>
          </p:cNvPr>
          <p:cNvSpPr txBox="1"/>
          <p:nvPr/>
        </p:nvSpPr>
        <p:spPr>
          <a:xfrm>
            <a:off x="3336321" y="2559392"/>
            <a:ext cx="6351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THP-1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4D71B0D-600A-DA17-CA50-EDB237179A93}"/>
              </a:ext>
            </a:extLst>
          </p:cNvPr>
          <p:cNvSpPr txBox="1"/>
          <p:nvPr/>
        </p:nvSpPr>
        <p:spPr>
          <a:xfrm>
            <a:off x="3336321" y="4024952"/>
            <a:ext cx="5485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U937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1A8F7655-E50E-DF36-9BE6-8A99E1CD06EC}"/>
              </a:ext>
            </a:extLst>
          </p:cNvPr>
          <p:cNvSpPr txBox="1"/>
          <p:nvPr/>
        </p:nvSpPr>
        <p:spPr>
          <a:xfrm>
            <a:off x="3336320" y="5447767"/>
            <a:ext cx="8354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MV-4-11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86ED591-A19A-A3ED-6A19-0E75C604975B}"/>
              </a:ext>
            </a:extLst>
          </p:cNvPr>
          <p:cNvSpPr txBox="1"/>
          <p:nvPr/>
        </p:nvSpPr>
        <p:spPr>
          <a:xfrm>
            <a:off x="5158997" y="1167399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MOLM-13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14B7117-7101-BA9A-63BD-D2EBB1FE4E80}"/>
              </a:ext>
            </a:extLst>
          </p:cNvPr>
          <p:cNvSpPr txBox="1"/>
          <p:nvPr/>
        </p:nvSpPr>
        <p:spPr>
          <a:xfrm>
            <a:off x="5158996" y="2559392"/>
            <a:ext cx="6206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HL-60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CE5E7EF-F9F6-175C-249C-9AC1D3249BD1}"/>
              </a:ext>
            </a:extLst>
          </p:cNvPr>
          <p:cNvSpPr txBox="1"/>
          <p:nvPr/>
        </p:nvSpPr>
        <p:spPr>
          <a:xfrm>
            <a:off x="5158996" y="4024952"/>
            <a:ext cx="60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Jurkat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ACADE5D-73CA-ECF9-8DD4-D12C3EF0D5F4}"/>
              </a:ext>
            </a:extLst>
          </p:cNvPr>
          <p:cNvSpPr txBox="1"/>
          <p:nvPr/>
        </p:nvSpPr>
        <p:spPr>
          <a:xfrm>
            <a:off x="5158995" y="5447767"/>
            <a:ext cx="681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MG-63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graphicFrame>
        <p:nvGraphicFramePr>
          <p:cNvPr id="27" name="表格 26">
            <a:extLst>
              <a:ext uri="{FF2B5EF4-FFF2-40B4-BE49-F238E27FC236}">
                <a16:creationId xmlns:a16="http://schemas.microsoft.com/office/drawing/2014/main" id="{0D2C36F3-A88E-0011-DB8D-FE6FF3D9A67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9337769"/>
              </p:ext>
            </p:extLst>
          </p:nvPr>
        </p:nvGraphicFramePr>
        <p:xfrm>
          <a:off x="8570611" y="918691"/>
          <a:ext cx="3537372" cy="3715619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51583">
                  <a:extLst>
                    <a:ext uri="{9D8B030D-6E8A-4147-A177-3AD203B41FA5}">
                      <a16:colId xmlns:a16="http://schemas.microsoft.com/office/drawing/2014/main" val="345223698"/>
                    </a:ext>
                  </a:extLst>
                </a:gridCol>
                <a:gridCol w="998167">
                  <a:extLst>
                    <a:ext uri="{9D8B030D-6E8A-4147-A177-3AD203B41FA5}">
                      <a16:colId xmlns:a16="http://schemas.microsoft.com/office/drawing/2014/main" val="1518020989"/>
                    </a:ext>
                  </a:extLst>
                </a:gridCol>
                <a:gridCol w="681916">
                  <a:extLst>
                    <a:ext uri="{9D8B030D-6E8A-4147-A177-3AD203B41FA5}">
                      <a16:colId xmlns:a16="http://schemas.microsoft.com/office/drawing/2014/main" val="1388953938"/>
                    </a:ext>
                  </a:extLst>
                </a:gridCol>
                <a:gridCol w="1205706">
                  <a:extLst>
                    <a:ext uri="{9D8B030D-6E8A-4147-A177-3AD203B41FA5}">
                      <a16:colId xmlns:a16="http://schemas.microsoft.com/office/drawing/2014/main" val="839087929"/>
                    </a:ext>
                  </a:extLst>
                </a:gridCol>
              </a:tblGrid>
              <a:tr h="44771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ell Line Nam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Primary Diseas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Linea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ineage Subtyp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51323951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U937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ukem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loo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M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620132906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V-4-1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Leukemi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Bloo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M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234938503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HP-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ukem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Bloo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M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899427177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HL-6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ukem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loo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M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625881990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OLM-1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ukem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loo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M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03223710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E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ukem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loo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L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660542010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Jurka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eukemi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Bloo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L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2343125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Raj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ymph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ymphocy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 Hodgkin Lymph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594326653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Daudi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ymph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ymphocy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on Hodgkin Lymph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133371507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-123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ymph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Lymphocyt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Hodgkin Lymph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951421474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NCI-H929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yel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Plasma Cel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Multiple Myelom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680071857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U266B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Myelom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Plasma Cel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Multiple Myelom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960331128"/>
                  </a:ext>
                </a:extLst>
              </a:tr>
              <a:tr h="229538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DHL4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ymphoma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ymphocyte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on Hodgkin Lymphoma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426013028"/>
                  </a:ext>
                </a:extLst>
              </a:tr>
              <a:tr h="283912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549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on-Small Cell Lung Cancer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Lung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等线" panose="02010600030101010101" pitchFamily="2" charset="-122"/>
                          <a:ea typeface="等线" panose="02010600030101010101" pitchFamily="2" charset="-122"/>
                        </a:rPr>
                        <a:t>Non-Small Cell Lung Cancer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75901340"/>
                  </a:ext>
                </a:extLst>
              </a:tr>
            </a:tbl>
          </a:graphicData>
        </a:graphic>
      </p:graphicFrame>
      <p:cxnSp>
        <p:nvCxnSpPr>
          <p:cNvPr id="30" name="直接箭头连接符 29">
            <a:extLst>
              <a:ext uri="{FF2B5EF4-FFF2-40B4-BE49-F238E27FC236}">
                <a16:creationId xmlns:a16="http://schemas.microsoft.com/office/drawing/2014/main" id="{DADBCEF2-59EE-D435-0710-A6021890828C}"/>
              </a:ext>
            </a:extLst>
          </p:cNvPr>
          <p:cNvCxnSpPr>
            <a:cxnSpLocks/>
          </p:cNvCxnSpPr>
          <p:nvPr/>
        </p:nvCxnSpPr>
        <p:spPr>
          <a:xfrm flipV="1">
            <a:off x="276686" y="802852"/>
            <a:ext cx="0" cy="5836043"/>
          </a:xfrm>
          <a:prstGeom prst="straightConnector1">
            <a:avLst/>
          </a:prstGeom>
          <a:ln w="15875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文本框 30">
            <a:extLst>
              <a:ext uri="{FF2B5EF4-FFF2-40B4-BE49-F238E27FC236}">
                <a16:creationId xmlns:a16="http://schemas.microsoft.com/office/drawing/2014/main" id="{7805D140-9B72-60C3-4BDF-3AD79FCDB149}"/>
              </a:ext>
            </a:extLst>
          </p:cNvPr>
          <p:cNvSpPr txBox="1"/>
          <p:nvPr/>
        </p:nvSpPr>
        <p:spPr>
          <a:xfrm>
            <a:off x="12763" y="3563811"/>
            <a:ext cx="369332" cy="581249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200" b="1" dirty="0"/>
              <a:t>Counts</a:t>
            </a:r>
            <a:endParaRPr lang="zh-CN" altLang="en-US" sz="1200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F2470F2-6ABC-F916-8BC4-EF17EE313C40}"/>
              </a:ext>
            </a:extLst>
          </p:cNvPr>
          <p:cNvSpPr txBox="1"/>
          <p:nvPr/>
        </p:nvSpPr>
        <p:spPr>
          <a:xfrm>
            <a:off x="7022325" y="1167399"/>
            <a:ext cx="7553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NK92MI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4EF2000-28AD-7AD9-15BA-DEB36B284E1F}"/>
              </a:ext>
            </a:extLst>
          </p:cNvPr>
          <p:cNvSpPr txBox="1"/>
          <p:nvPr/>
        </p:nvSpPr>
        <p:spPr>
          <a:xfrm>
            <a:off x="7022324" y="2559392"/>
            <a:ext cx="6431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LAN-1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A5027322-D492-4802-A1FD-C43B80B66121}"/>
              </a:ext>
            </a:extLst>
          </p:cNvPr>
          <p:cNvSpPr/>
          <p:nvPr/>
        </p:nvSpPr>
        <p:spPr>
          <a:xfrm flipV="1">
            <a:off x="577081" y="6323501"/>
            <a:ext cx="7622614" cy="16821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F8BB4F14-39C1-8305-D1CD-78936A709FC6}"/>
              </a:ext>
            </a:extLst>
          </p:cNvPr>
          <p:cNvSpPr txBox="1"/>
          <p:nvPr/>
        </p:nvSpPr>
        <p:spPr>
          <a:xfrm>
            <a:off x="3770358" y="6600245"/>
            <a:ext cx="13452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D38 Expression</a:t>
            </a:r>
            <a:endParaRPr lang="zh-CN" altLang="en-US" sz="1200" b="1" dirty="0"/>
          </a:p>
        </p:txBody>
      </p:sp>
      <p:cxnSp>
        <p:nvCxnSpPr>
          <p:cNvPr id="53" name="直接箭头连接符 52">
            <a:extLst>
              <a:ext uri="{FF2B5EF4-FFF2-40B4-BE49-F238E27FC236}">
                <a16:creationId xmlns:a16="http://schemas.microsoft.com/office/drawing/2014/main" id="{B9CB15B6-F97B-1A40-1ECC-3A00436177D0}"/>
              </a:ext>
            </a:extLst>
          </p:cNvPr>
          <p:cNvCxnSpPr>
            <a:cxnSpLocks/>
          </p:cNvCxnSpPr>
          <p:nvPr/>
        </p:nvCxnSpPr>
        <p:spPr>
          <a:xfrm>
            <a:off x="266412" y="6649497"/>
            <a:ext cx="8208000" cy="0"/>
          </a:xfrm>
          <a:prstGeom prst="straightConnector1">
            <a:avLst/>
          </a:prstGeom>
          <a:ln w="15875">
            <a:solidFill>
              <a:schemeClr val="bg1">
                <a:lumMod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4" name="图片 53">
            <a:extLst>
              <a:ext uri="{FF2B5EF4-FFF2-40B4-BE49-F238E27FC236}">
                <a16:creationId xmlns:a16="http://schemas.microsoft.com/office/drawing/2014/main" id="{00000000-0008-0000-0000-000021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16" y="802852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00000000-0008-0000-0000-00001C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16" y="2261780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00000000-0008-0000-0000-00001F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3989" y="791771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00000000-0008-0000-0000-000024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3989" y="2261780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00000000-0008-0000-0000-000022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3516" y="3731789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00000000-0008-0000-0000-000025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1337" y="5201798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00000000-0008-0000-0000-00001D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27414" y="3731378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00000000-0008-0000-0000-00001E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17115" y="5200976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00000000-0008-0000-0000-000023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5845" y="791770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00000000-0008-0000-0000-00001B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5844" y="2260957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00000000-0008-0000-0000-000029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63127" y="5192404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6" name="图片 65">
            <a:extLst>
              <a:ext uri="{FF2B5EF4-FFF2-40B4-BE49-F238E27FC236}">
                <a16:creationId xmlns:a16="http://schemas.microsoft.com/office/drawing/2014/main" id="{00000000-0008-0000-0000-000026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2030" y="791769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7" name="图片 66">
            <a:extLst>
              <a:ext uri="{FF2B5EF4-FFF2-40B4-BE49-F238E27FC236}">
                <a16:creationId xmlns:a16="http://schemas.microsoft.com/office/drawing/2014/main" id="{00000000-0008-0000-0000-00002A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2029" y="2228938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E4DBB184-FCF3-1B8F-947C-B25E9F29462C}"/>
              </a:ext>
            </a:extLst>
          </p:cNvPr>
          <p:cNvSpPr txBox="1"/>
          <p:nvPr/>
        </p:nvSpPr>
        <p:spPr>
          <a:xfrm>
            <a:off x="7016876" y="4024951"/>
            <a:ext cx="9156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SU-DHL-4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00000000-0008-0000-0000-00002B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2028" y="3749401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0000000-0008-0000-0000-00002C00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02027" y="5187622"/>
            <a:ext cx="2295525" cy="14319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C7ACFD16-943B-E6EA-290E-15C176FEE240}"/>
              </a:ext>
            </a:extLst>
          </p:cNvPr>
          <p:cNvSpPr txBox="1"/>
          <p:nvPr/>
        </p:nvSpPr>
        <p:spPr>
          <a:xfrm>
            <a:off x="7016875" y="5444611"/>
            <a:ext cx="5421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</a:rPr>
              <a:t>A549</a:t>
            </a:r>
            <a:endParaRPr lang="zh-CN" altLang="en-US" sz="12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350737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BA01CCB4-3CEE-B012-977F-73486DC6CF41}"/>
              </a:ext>
            </a:extLst>
          </p:cNvPr>
          <p:cNvSpPr txBox="1"/>
          <p:nvPr/>
        </p:nvSpPr>
        <p:spPr>
          <a:xfrm>
            <a:off x="14725" y="10276"/>
            <a:ext cx="2666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3.</a:t>
            </a:r>
            <a:endParaRPr lang="zh-CN" altLang="en-US" sz="2000" b="1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19E709EC-41CA-416C-C2B0-80512A7AC55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50667" y="531973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46EAF91-2ADA-4706-681E-57EE10763C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29819" y="531973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120DAB2-3452-C74C-AE0D-976949D0BE0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08972" y="531973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F243F2C0-5C51-D4AD-D968-E683E74C41C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88125" y="531973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0E4027C-ECF8-C783-AF97-45C6DD3F11F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067278" y="531973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8350590F-3333-F137-7321-C63EEF6DDB6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0667" y="2287759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21AB55E-5165-27A6-746B-F270E8F7DBE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629819" y="2287759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23803E0-CB34-8D8C-7A42-0708D3580C7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108972" y="2287759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D45F9EB7-7B88-3F3C-6E0D-4E4A7A29B1D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588125" y="2287759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D0C82AB-F95A-6D9A-1E26-27851250493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067278" y="2287759"/>
            <a:ext cx="2026697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0CDA2FC-FEFF-D2C2-5774-342F7D8F008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0667" y="4043545"/>
            <a:ext cx="2008183" cy="144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4FC59A00-EFAB-0FA3-AF62-EC74C928350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629819" y="4043545"/>
            <a:ext cx="2008183" cy="1440000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15" name="表格 14">
            <a:extLst>
              <a:ext uri="{FF2B5EF4-FFF2-40B4-BE49-F238E27FC236}">
                <a16:creationId xmlns:a16="http://schemas.microsoft.com/office/drawing/2014/main" id="{6BB80FA8-65D4-F892-57B3-A564E31739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6564026"/>
              </p:ext>
            </p:extLst>
          </p:nvPr>
        </p:nvGraphicFramePr>
        <p:xfrm>
          <a:off x="4919662" y="3812548"/>
          <a:ext cx="6477000" cy="23114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76300">
                  <a:extLst>
                    <a:ext uri="{9D8B030D-6E8A-4147-A177-3AD203B41FA5}">
                      <a16:colId xmlns:a16="http://schemas.microsoft.com/office/drawing/2014/main" val="62498903"/>
                    </a:ext>
                  </a:extLst>
                </a:gridCol>
                <a:gridCol w="800100">
                  <a:extLst>
                    <a:ext uri="{9D8B030D-6E8A-4147-A177-3AD203B41FA5}">
                      <a16:colId xmlns:a16="http://schemas.microsoft.com/office/drawing/2014/main" val="118226719"/>
                    </a:ext>
                  </a:extLst>
                </a:gridCol>
                <a:gridCol w="723900">
                  <a:extLst>
                    <a:ext uri="{9D8B030D-6E8A-4147-A177-3AD203B41FA5}">
                      <a16:colId xmlns:a16="http://schemas.microsoft.com/office/drawing/2014/main" val="490282851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4077707850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1732998646"/>
                    </a:ext>
                  </a:extLst>
                </a:gridCol>
                <a:gridCol w="1104900">
                  <a:extLst>
                    <a:ext uri="{9D8B030D-6E8A-4147-A177-3AD203B41FA5}">
                      <a16:colId xmlns:a16="http://schemas.microsoft.com/office/drawing/2014/main" val="2656961856"/>
                    </a:ext>
                  </a:extLst>
                </a:gridCol>
                <a:gridCol w="876300">
                  <a:extLst>
                    <a:ext uri="{9D8B030D-6E8A-4147-A177-3AD203B41FA5}">
                      <a16:colId xmlns:a16="http://schemas.microsoft.com/office/drawing/2014/main" val="723932125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3947301302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Loading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koff(1/s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kon(1/Ms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KD(M)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Response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Loading Height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Association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FullR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403468614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Daratumuma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3.64E-0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8.15E+0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4.47E-008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3359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053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98757228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Isatuxima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.37E-0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.17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1.09E-008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5278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243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96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83147745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4A8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&lt;1.00E-0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.58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4156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097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92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077315897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12C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&lt;1.00E-0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.61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453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107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92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953730341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25B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3.62E-0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3.80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9.53E-009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5019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136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86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400096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26B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&lt;1.00E-0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2.02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4829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096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95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63519108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65A7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7.13E-0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3.76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1.90E-008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432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094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92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521592499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35G5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&lt;1.00E-0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3.72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4991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073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84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346294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82G1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&lt;1.00E-0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.93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4176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061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96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9998426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6C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&lt;1.00E-0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1.00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3353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132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95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211986570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32D6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3.89E-0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4.79E+0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8.13E-009</a:t>
                      </a:r>
                      <a:endParaRPr lang="en-US" sz="10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3609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1.211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CD38-His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>
                          <a:effectLst/>
                        </a:rPr>
                        <a:t>0.985</a:t>
                      </a:r>
                      <a:endParaRPr lang="en-US" altLang="zh-CN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500074573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>
                          <a:effectLst/>
                        </a:rPr>
                        <a:t>NC Ab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/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/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FF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/</a:t>
                      </a: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 dirty="0">
                          <a:effectLst/>
                        </a:rPr>
                        <a:t>0.0864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u="none" strike="noStrike" dirty="0">
                          <a:effectLst/>
                        </a:rPr>
                        <a:t>1.2042</a:t>
                      </a:r>
                      <a:endParaRPr lang="en-US" altLang="zh-CN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u="none" strike="noStrike" dirty="0">
                          <a:effectLst/>
                        </a:rPr>
                        <a:t>CD38-His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/</a:t>
                      </a: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829410653"/>
                  </a:ext>
                </a:extLst>
              </a:tr>
            </a:tbl>
          </a:graphicData>
        </a:graphic>
      </p:graphicFrame>
      <p:sp>
        <p:nvSpPr>
          <p:cNvPr id="16" name="文本框 15">
            <a:extLst>
              <a:ext uri="{FF2B5EF4-FFF2-40B4-BE49-F238E27FC236}">
                <a16:creationId xmlns:a16="http://schemas.microsoft.com/office/drawing/2014/main" id="{93308D52-522D-59DA-2B17-BB873A9AD7EB}"/>
              </a:ext>
            </a:extLst>
          </p:cNvPr>
          <p:cNvSpPr txBox="1"/>
          <p:nvPr/>
        </p:nvSpPr>
        <p:spPr>
          <a:xfrm>
            <a:off x="1161636" y="1585330"/>
            <a:ext cx="1027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Daratumumab</a:t>
            </a:r>
            <a:endParaRPr lang="zh-CN" altLang="en-US" sz="10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ED2F686-D95E-235B-F612-12C04CFA1B45}"/>
              </a:ext>
            </a:extLst>
          </p:cNvPr>
          <p:cNvSpPr txBox="1"/>
          <p:nvPr/>
        </p:nvSpPr>
        <p:spPr>
          <a:xfrm>
            <a:off x="3639304" y="1585329"/>
            <a:ext cx="8210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Isatuximab</a:t>
            </a:r>
            <a:endParaRPr lang="zh-CN" altLang="en-US" sz="10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B0F659A6-C9EB-4A75-83A9-46E86E83C1B7}"/>
              </a:ext>
            </a:extLst>
          </p:cNvPr>
          <p:cNvSpPr txBox="1"/>
          <p:nvPr/>
        </p:nvSpPr>
        <p:spPr>
          <a:xfrm>
            <a:off x="6111687" y="1585328"/>
            <a:ext cx="412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4A8</a:t>
            </a:r>
            <a:endParaRPr lang="zh-CN" altLang="en-US" sz="10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A1F10102-3C3F-7599-574A-3DE6D9D48E20}"/>
              </a:ext>
            </a:extLst>
          </p:cNvPr>
          <p:cNvSpPr txBox="1"/>
          <p:nvPr/>
        </p:nvSpPr>
        <p:spPr>
          <a:xfrm>
            <a:off x="8603248" y="1600106"/>
            <a:ext cx="5469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12C10</a:t>
            </a:r>
            <a:endParaRPr lang="zh-CN" altLang="en-US" sz="10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FD7E6CD-A2D6-E87D-C909-D9CD02710B7B}"/>
              </a:ext>
            </a:extLst>
          </p:cNvPr>
          <p:cNvSpPr txBox="1"/>
          <p:nvPr/>
        </p:nvSpPr>
        <p:spPr>
          <a:xfrm>
            <a:off x="11075828" y="1582008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25B5</a:t>
            </a:r>
            <a:endParaRPr lang="zh-CN" altLang="en-US" sz="10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6C0F2EAF-FBB7-A1E2-45C5-38DED5649747}"/>
              </a:ext>
            </a:extLst>
          </p:cNvPr>
          <p:cNvSpPr txBox="1"/>
          <p:nvPr/>
        </p:nvSpPr>
        <p:spPr>
          <a:xfrm>
            <a:off x="1162904" y="3350705"/>
            <a:ext cx="4732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26B4</a:t>
            </a:r>
            <a:endParaRPr lang="zh-CN" altLang="en-US" sz="1000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069970D-681B-3719-6BEC-8F17861AA219}"/>
              </a:ext>
            </a:extLst>
          </p:cNvPr>
          <p:cNvSpPr txBox="1"/>
          <p:nvPr/>
        </p:nvSpPr>
        <p:spPr>
          <a:xfrm>
            <a:off x="3640572" y="3350704"/>
            <a:ext cx="48282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65A7</a:t>
            </a:r>
            <a:endParaRPr lang="zh-CN" altLang="en-US" sz="1000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61DFE7D-9E40-1769-35C7-FDF43418B722}"/>
              </a:ext>
            </a:extLst>
          </p:cNvPr>
          <p:cNvSpPr txBox="1"/>
          <p:nvPr/>
        </p:nvSpPr>
        <p:spPr>
          <a:xfrm>
            <a:off x="6112955" y="3350703"/>
            <a:ext cx="48603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35G5</a:t>
            </a:r>
            <a:endParaRPr lang="zh-CN" altLang="en-US" sz="1000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2794BBE-7BB4-34AB-D776-68B5442C181D}"/>
              </a:ext>
            </a:extLst>
          </p:cNvPr>
          <p:cNvSpPr txBox="1"/>
          <p:nvPr/>
        </p:nvSpPr>
        <p:spPr>
          <a:xfrm>
            <a:off x="8604516" y="3365481"/>
            <a:ext cx="5565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82G10</a:t>
            </a:r>
            <a:endParaRPr lang="zh-CN" altLang="en-US" sz="1000" b="1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E1BBF30-ED7F-572D-90C4-30A9C059FD0F}"/>
              </a:ext>
            </a:extLst>
          </p:cNvPr>
          <p:cNvSpPr txBox="1"/>
          <p:nvPr/>
        </p:nvSpPr>
        <p:spPr>
          <a:xfrm>
            <a:off x="11077096" y="3347383"/>
            <a:ext cx="4764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16C2</a:t>
            </a:r>
            <a:endParaRPr lang="zh-CN" altLang="en-US" sz="10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2283900-E107-AC58-5E31-22E5269C4F02}"/>
              </a:ext>
            </a:extLst>
          </p:cNvPr>
          <p:cNvSpPr txBox="1"/>
          <p:nvPr/>
        </p:nvSpPr>
        <p:spPr>
          <a:xfrm>
            <a:off x="1155930" y="5108624"/>
            <a:ext cx="4876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32D6</a:t>
            </a:r>
            <a:endParaRPr lang="zh-CN" altLang="en-US" sz="10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6938ADE0-12B6-EB5A-5261-2099BF952ED5}"/>
              </a:ext>
            </a:extLst>
          </p:cNvPr>
          <p:cNvSpPr txBox="1"/>
          <p:nvPr/>
        </p:nvSpPr>
        <p:spPr>
          <a:xfrm>
            <a:off x="3633598" y="5108623"/>
            <a:ext cx="56137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NC Ab</a:t>
            </a:r>
            <a:endParaRPr lang="zh-CN" altLang="en-US" sz="1000" b="1" dirty="0"/>
          </a:p>
        </p:txBody>
      </p:sp>
    </p:spTree>
    <p:extLst>
      <p:ext uri="{BB962C8B-B14F-4D97-AF65-F5344CB8AC3E}">
        <p14:creationId xmlns:p14="http://schemas.microsoft.com/office/powerpoint/2010/main" val="29105230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4FC9660-F6D3-3E08-77D6-8B54EFF9E06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BEE57A49-E93F-7338-5B57-83A628500B68}"/>
              </a:ext>
            </a:extLst>
          </p:cNvPr>
          <p:cNvSpPr txBox="1"/>
          <p:nvPr/>
        </p:nvSpPr>
        <p:spPr>
          <a:xfrm>
            <a:off x="14725" y="10276"/>
            <a:ext cx="2666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4.</a:t>
            </a:r>
            <a:endParaRPr lang="zh-CN" altLang="en-US" sz="2000" b="1" dirty="0"/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8EA61FB4-1B32-22F5-18E7-7918A6CE94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0757749"/>
              </p:ext>
            </p:extLst>
          </p:nvPr>
        </p:nvGraphicFramePr>
        <p:xfrm>
          <a:off x="8380413" y="1130883"/>
          <a:ext cx="3730625" cy="2317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4663758" imgH="2863815" progId="Prism10.Document">
                  <p:embed/>
                </p:oleObj>
              </mc:Choice>
              <mc:Fallback>
                <p:oleObj name="Prism 10" r:id="rId3" imgW="4663758" imgH="2863815" progId="Prism10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0CC516F0-8509-29A7-7BB0-9BE26D7AD44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380413" y="1130883"/>
                        <a:ext cx="3730625" cy="23177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83F269C6-2DB1-355B-16E0-F39149F7E260}"/>
              </a:ext>
            </a:extLst>
          </p:cNvPr>
          <p:cNvSpPr txBox="1"/>
          <p:nvPr/>
        </p:nvSpPr>
        <p:spPr>
          <a:xfrm>
            <a:off x="152401" y="598337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4A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96D2C72-2C04-F9C2-E5A9-8566DC2B3B33}"/>
              </a:ext>
            </a:extLst>
          </p:cNvPr>
          <p:cNvSpPr txBox="1"/>
          <p:nvPr/>
        </p:nvSpPr>
        <p:spPr>
          <a:xfrm>
            <a:off x="4475434" y="598337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4B</a:t>
            </a:r>
            <a:endParaRPr lang="zh-CN" altLang="en-US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68ACF5FC-65A1-ABC9-05C7-007AC619BC00}"/>
              </a:ext>
            </a:extLst>
          </p:cNvPr>
          <p:cNvSpPr txBox="1"/>
          <p:nvPr/>
        </p:nvSpPr>
        <p:spPr>
          <a:xfrm>
            <a:off x="8340524" y="598337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4C</a:t>
            </a:r>
            <a:endParaRPr lang="zh-CN" altLang="en-US" b="1" dirty="0"/>
          </a:p>
        </p:txBody>
      </p:sp>
      <p:graphicFrame>
        <p:nvGraphicFramePr>
          <p:cNvPr id="19" name="对象 18">
            <a:extLst>
              <a:ext uri="{FF2B5EF4-FFF2-40B4-BE49-F238E27FC236}">
                <a16:creationId xmlns:a16="http://schemas.microsoft.com/office/drawing/2014/main" id="{650DCAB5-D8A3-406A-7D88-586F6C2E26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4520307"/>
              </p:ext>
            </p:extLst>
          </p:nvPr>
        </p:nvGraphicFramePr>
        <p:xfrm>
          <a:off x="38757" y="1124532"/>
          <a:ext cx="4151770" cy="234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5" imgW="5134815" imgH="2863815" progId="Prism10.Document">
                  <p:embed/>
                </p:oleObj>
              </mc:Choice>
              <mc:Fallback>
                <p:oleObj name="Prism 10" r:id="rId5" imgW="5134815" imgH="2863815" progId="Prism10.Document">
                  <p:embed/>
                  <p:pic>
                    <p:nvPicPr>
                      <p:cNvPr id="19" name="对象 18">
                        <a:extLst>
                          <a:ext uri="{FF2B5EF4-FFF2-40B4-BE49-F238E27FC236}">
                            <a16:creationId xmlns:a16="http://schemas.microsoft.com/office/drawing/2014/main" id="{AAAA4EE3-50AF-AA0B-8BAA-835B7868E0D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757" y="1124532"/>
                        <a:ext cx="4151770" cy="2340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" name="对象 19">
            <a:extLst>
              <a:ext uri="{FF2B5EF4-FFF2-40B4-BE49-F238E27FC236}">
                <a16:creationId xmlns:a16="http://schemas.microsoft.com/office/drawing/2014/main" id="{3227E0D2-E1F7-DAA0-E92F-F8CF449810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5243254"/>
              </p:ext>
            </p:extLst>
          </p:nvPr>
        </p:nvGraphicFramePr>
        <p:xfrm>
          <a:off x="4389438" y="1119770"/>
          <a:ext cx="3795712" cy="2339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7" imgW="4692568" imgH="2863815" progId="Prism10.Document">
                  <p:embed/>
                </p:oleObj>
              </mc:Choice>
              <mc:Fallback>
                <p:oleObj name="Prism 10" r:id="rId7" imgW="4692568" imgH="2863815" progId="Prism10.Document">
                  <p:embed/>
                  <p:pic>
                    <p:nvPicPr>
                      <p:cNvPr id="20" name="对象 19">
                        <a:extLst>
                          <a:ext uri="{FF2B5EF4-FFF2-40B4-BE49-F238E27FC236}">
                            <a16:creationId xmlns:a16="http://schemas.microsoft.com/office/drawing/2014/main" id="{17EFF443-7850-109C-D852-1344973D841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389438" y="1119770"/>
                        <a:ext cx="3795712" cy="233997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6325341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BA01CCB4-3CEE-B012-977F-73486DC6CF41}"/>
              </a:ext>
            </a:extLst>
          </p:cNvPr>
          <p:cNvSpPr txBox="1"/>
          <p:nvPr/>
        </p:nvSpPr>
        <p:spPr>
          <a:xfrm>
            <a:off x="14725" y="10276"/>
            <a:ext cx="2666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5.</a:t>
            </a:r>
            <a:endParaRPr lang="zh-CN" altLang="en-US" sz="2000" b="1" dirty="0"/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7A8F2A4E-6983-35EF-F255-79217835B2E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48125225"/>
              </p:ext>
            </p:extLst>
          </p:nvPr>
        </p:nvGraphicFramePr>
        <p:xfrm>
          <a:off x="149225" y="636588"/>
          <a:ext cx="3943350" cy="2257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5058466" imgH="2863815" progId="Prism9.Document">
                  <p:embed/>
                </p:oleObj>
              </mc:Choice>
              <mc:Fallback>
                <p:oleObj name="Prism 9" r:id="rId3" imgW="5058466" imgH="2863815" progId="Prism9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7A8F2A4E-6983-35EF-F255-79217835B2EC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49225" y="636588"/>
                        <a:ext cx="3943350" cy="22574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33C70D9C-7213-6C67-4015-DBFB5CABFA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0747729"/>
              </p:ext>
            </p:extLst>
          </p:nvPr>
        </p:nvGraphicFramePr>
        <p:xfrm>
          <a:off x="8150225" y="639763"/>
          <a:ext cx="3975100" cy="2252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5081515" imgH="2858054" progId="Prism9.Document">
                  <p:embed/>
                </p:oleObj>
              </mc:Choice>
              <mc:Fallback>
                <p:oleObj name="Prism 9" r:id="rId5" imgW="5081515" imgH="2858054" progId="Prism9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33C70D9C-7213-6C67-4015-DBFB5CABFA4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50225" y="639763"/>
                        <a:ext cx="3975100" cy="225266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对象 3">
            <a:extLst>
              <a:ext uri="{FF2B5EF4-FFF2-40B4-BE49-F238E27FC236}">
                <a16:creationId xmlns:a16="http://schemas.microsoft.com/office/drawing/2014/main" id="{DB7E2E76-9F35-B8BA-D164-C5DEC4A5F2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2412332"/>
              </p:ext>
            </p:extLst>
          </p:nvPr>
        </p:nvGraphicFramePr>
        <p:xfrm>
          <a:off x="158750" y="3182938"/>
          <a:ext cx="3941763" cy="2249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5038659" imgH="2858054" progId="Prism9.Document">
                  <p:embed/>
                </p:oleObj>
              </mc:Choice>
              <mc:Fallback>
                <p:oleObj name="Prism 9" r:id="rId7" imgW="5038659" imgH="2858054" progId="Prism9.Document">
                  <p:embed/>
                  <p:pic>
                    <p:nvPicPr>
                      <p:cNvPr id="4" name="对象 3">
                        <a:extLst>
                          <a:ext uri="{FF2B5EF4-FFF2-40B4-BE49-F238E27FC236}">
                            <a16:creationId xmlns:a16="http://schemas.microsoft.com/office/drawing/2014/main" id="{DB7E2E76-9F35-B8BA-D164-C5DEC4A5F2A9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8750" y="3182938"/>
                        <a:ext cx="3941763" cy="224948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FD57CC45-A3BF-2BB5-BC75-EC12D967BCA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34010065"/>
              </p:ext>
            </p:extLst>
          </p:nvPr>
        </p:nvGraphicFramePr>
        <p:xfrm>
          <a:off x="8081963" y="3187700"/>
          <a:ext cx="3871912" cy="2251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4968432" imgH="2858054" progId="Prism9.Document">
                  <p:embed/>
                </p:oleObj>
              </mc:Choice>
              <mc:Fallback>
                <p:oleObj name="Prism 9" r:id="rId9" imgW="4968432" imgH="2858054" progId="Prism9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FD57CC45-A3BF-2BB5-BC75-EC12D967BCA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081963" y="3187700"/>
                        <a:ext cx="3871912" cy="225107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对象 5">
            <a:extLst>
              <a:ext uri="{FF2B5EF4-FFF2-40B4-BE49-F238E27FC236}">
                <a16:creationId xmlns:a16="http://schemas.microsoft.com/office/drawing/2014/main" id="{9EA5EF3E-80CB-94EC-CE8B-D6473BAB532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0727233"/>
              </p:ext>
            </p:extLst>
          </p:nvPr>
        </p:nvGraphicFramePr>
        <p:xfrm>
          <a:off x="4141788" y="644525"/>
          <a:ext cx="3941762" cy="2252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5038659" imgH="2858054" progId="Prism9.Document">
                  <p:embed/>
                </p:oleObj>
              </mc:Choice>
              <mc:Fallback>
                <p:oleObj name="Prism 9" r:id="rId11" imgW="5038659" imgH="2858054" progId="Prism9.Document">
                  <p:embed/>
                  <p:pic>
                    <p:nvPicPr>
                      <p:cNvPr id="6" name="对象 5">
                        <a:extLst>
                          <a:ext uri="{FF2B5EF4-FFF2-40B4-BE49-F238E27FC236}">
                            <a16:creationId xmlns:a16="http://schemas.microsoft.com/office/drawing/2014/main" id="{9EA5EF3E-80CB-94EC-CE8B-D6473BAB5322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41788" y="644525"/>
                        <a:ext cx="3941762" cy="22526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6">
            <a:extLst>
              <a:ext uri="{FF2B5EF4-FFF2-40B4-BE49-F238E27FC236}">
                <a16:creationId xmlns:a16="http://schemas.microsoft.com/office/drawing/2014/main" id="{858FB2F9-8336-A95D-BDEE-A099BC8B89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42952452"/>
              </p:ext>
            </p:extLst>
          </p:nvPr>
        </p:nvGraphicFramePr>
        <p:xfrm>
          <a:off x="4097338" y="3187700"/>
          <a:ext cx="3943350" cy="2251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5038659" imgH="2858054" progId="Prism9.Document">
                  <p:embed/>
                </p:oleObj>
              </mc:Choice>
              <mc:Fallback>
                <p:oleObj name="Prism 9" r:id="rId13" imgW="5038659" imgH="2858054" progId="Prism9.Document">
                  <p:embed/>
                  <p:pic>
                    <p:nvPicPr>
                      <p:cNvPr id="7" name="对象 6">
                        <a:extLst>
                          <a:ext uri="{FF2B5EF4-FFF2-40B4-BE49-F238E27FC236}">
                            <a16:creationId xmlns:a16="http://schemas.microsoft.com/office/drawing/2014/main" id="{858FB2F9-8336-A95D-BDEE-A099BC8B89B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97338" y="3187700"/>
                        <a:ext cx="3943350" cy="225107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文本框 8">
            <a:extLst>
              <a:ext uri="{FF2B5EF4-FFF2-40B4-BE49-F238E27FC236}">
                <a16:creationId xmlns:a16="http://schemas.microsoft.com/office/drawing/2014/main" id="{B3DA6C9F-C607-DBB8-3C7F-7DEE042B5B3D}"/>
              </a:ext>
            </a:extLst>
          </p:cNvPr>
          <p:cNvSpPr txBox="1"/>
          <p:nvPr/>
        </p:nvSpPr>
        <p:spPr>
          <a:xfrm>
            <a:off x="191854" y="413795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5A</a:t>
            </a:r>
            <a:endParaRPr lang="zh-CN" altLang="en-US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779B4A76-7FDF-3D6C-F553-1C2151D13C5D}"/>
              </a:ext>
            </a:extLst>
          </p:cNvPr>
          <p:cNvSpPr txBox="1"/>
          <p:nvPr/>
        </p:nvSpPr>
        <p:spPr>
          <a:xfrm>
            <a:off x="4100933" y="41379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5B</a:t>
            </a:r>
            <a:endParaRPr lang="zh-CN" altLang="en-US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C81CD78-3F97-5806-FB10-AE3507A85074}"/>
              </a:ext>
            </a:extLst>
          </p:cNvPr>
          <p:cNvSpPr txBox="1"/>
          <p:nvPr/>
        </p:nvSpPr>
        <p:spPr>
          <a:xfrm>
            <a:off x="8069763" y="413795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5C</a:t>
            </a:r>
            <a:endParaRPr lang="zh-CN" altLang="en-US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ABBC3E9-26EA-DBF2-33E9-695BCE703850}"/>
              </a:ext>
            </a:extLst>
          </p:cNvPr>
          <p:cNvSpPr txBox="1"/>
          <p:nvPr/>
        </p:nvSpPr>
        <p:spPr>
          <a:xfrm>
            <a:off x="195392" y="2990424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5D</a:t>
            </a:r>
            <a:endParaRPr lang="zh-CN" altLang="en-US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F21B642-EE05-04F9-6563-6499E54B65A2}"/>
              </a:ext>
            </a:extLst>
          </p:cNvPr>
          <p:cNvSpPr txBox="1"/>
          <p:nvPr/>
        </p:nvSpPr>
        <p:spPr>
          <a:xfrm>
            <a:off x="4104471" y="2990424"/>
            <a:ext cx="4331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5E</a:t>
            </a:r>
            <a:endParaRPr lang="zh-CN" altLang="en-US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9A707C8-4962-96D9-09C7-40B97B2F8F5B}"/>
              </a:ext>
            </a:extLst>
          </p:cNvPr>
          <p:cNvSpPr txBox="1"/>
          <p:nvPr/>
        </p:nvSpPr>
        <p:spPr>
          <a:xfrm>
            <a:off x="8073301" y="2990424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5F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35130502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3EC425E-F8CC-7F69-1F10-C8404C79627F}"/>
              </a:ext>
            </a:extLst>
          </p:cNvPr>
          <p:cNvSpPr txBox="1"/>
          <p:nvPr/>
        </p:nvSpPr>
        <p:spPr>
          <a:xfrm>
            <a:off x="372122" y="413795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6A</a:t>
            </a:r>
            <a:endParaRPr lang="zh-CN" altLang="en-US" b="1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4322942-DC87-90C6-4C12-FD9B6FABCEC4}"/>
              </a:ext>
            </a:extLst>
          </p:cNvPr>
          <p:cNvSpPr txBox="1"/>
          <p:nvPr/>
        </p:nvSpPr>
        <p:spPr>
          <a:xfrm>
            <a:off x="5809648" y="41379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6B</a:t>
            </a:r>
            <a:endParaRPr lang="zh-CN" altLang="en-US" b="1" dirty="0">
              <a:highlight>
                <a:srgbClr val="FFFF00"/>
              </a:highlight>
            </a:endParaRPr>
          </a:p>
        </p:txBody>
      </p:sp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2EEFD8FA-8436-C638-DCE9-D149927ACD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4710864"/>
              </p:ext>
            </p:extLst>
          </p:nvPr>
        </p:nvGraphicFramePr>
        <p:xfrm>
          <a:off x="420687" y="750888"/>
          <a:ext cx="4308800" cy="25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" imgW="4881640" imgH="2858054" progId="Prism10.Document">
                  <p:embed/>
                </p:oleObj>
              </mc:Choice>
              <mc:Fallback>
                <p:oleObj name="Prism 10" r:id="rId3" imgW="4881640" imgH="2858054" progId="Prism10.Document">
                  <p:embed/>
                  <p:pic>
                    <p:nvPicPr>
                      <p:cNvPr id="5" name="对象 4">
                        <a:extLst>
                          <a:ext uri="{FF2B5EF4-FFF2-40B4-BE49-F238E27FC236}">
                            <a16:creationId xmlns:a16="http://schemas.microsoft.com/office/drawing/2014/main" id="{2EEFD8FA-8436-C638-DCE9-D149927ACD7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0687" y="750888"/>
                        <a:ext cx="4308800" cy="2520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" name="组合 5">
            <a:extLst>
              <a:ext uri="{FF2B5EF4-FFF2-40B4-BE49-F238E27FC236}">
                <a16:creationId xmlns:a16="http://schemas.microsoft.com/office/drawing/2014/main" id="{D392235D-E723-1A98-C201-FA1C492C685A}"/>
              </a:ext>
            </a:extLst>
          </p:cNvPr>
          <p:cNvGrpSpPr>
            <a:grpSpLocks noChangeAspect="1"/>
          </p:cNvGrpSpPr>
          <p:nvPr/>
        </p:nvGrpSpPr>
        <p:grpSpPr>
          <a:xfrm>
            <a:off x="5631848" y="750888"/>
            <a:ext cx="5993220" cy="3428103"/>
            <a:chOff x="5809648" y="675101"/>
            <a:chExt cx="5993220" cy="3428103"/>
          </a:xfrm>
        </p:grpSpPr>
        <p:pic>
          <p:nvPicPr>
            <p:cNvPr id="10" name="图片 9" descr="图片包含 游戏机, 过滤网&#10;&#10;描述已自动生成">
              <a:extLst>
                <a:ext uri="{FF2B5EF4-FFF2-40B4-BE49-F238E27FC236}">
                  <a16:creationId xmlns:a16="http://schemas.microsoft.com/office/drawing/2014/main" id="{76408EA0-9479-1CEB-8AE6-FE42A5EAF1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155" b="1295"/>
            <a:stretch/>
          </p:blipFill>
          <p:spPr>
            <a:xfrm rot="16200000">
              <a:off x="7743008" y="72117"/>
              <a:ext cx="2957856" cy="5014487"/>
            </a:xfrm>
            <a:prstGeom prst="rect">
              <a:avLst/>
            </a:prstGeom>
          </p:spPr>
        </p:pic>
        <p:cxnSp>
          <p:nvCxnSpPr>
            <p:cNvPr id="12" name="直接连接符 11">
              <a:extLst>
                <a:ext uri="{FF2B5EF4-FFF2-40B4-BE49-F238E27FC236}">
                  <a16:creationId xmlns:a16="http://schemas.microsoft.com/office/drawing/2014/main" id="{4B4F322B-2C72-19CA-F603-1ADC46C19089}"/>
                </a:ext>
              </a:extLst>
            </p:cNvPr>
            <p:cNvCxnSpPr>
              <a:cxnSpLocks/>
            </p:cNvCxnSpPr>
            <p:nvPr/>
          </p:nvCxnSpPr>
          <p:spPr>
            <a:xfrm>
              <a:off x="6714690" y="939274"/>
              <a:ext cx="5014489" cy="0"/>
            </a:xfrm>
            <a:prstGeom prst="line">
              <a:avLst/>
            </a:prstGeom>
            <a:ln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3791E35-8FCB-1F45-5C74-443F8E6F2971}"/>
                </a:ext>
              </a:extLst>
            </p:cNvPr>
            <p:cNvSpPr txBox="1"/>
            <p:nvPr/>
          </p:nvSpPr>
          <p:spPr>
            <a:xfrm>
              <a:off x="8699248" y="675101"/>
              <a:ext cx="16321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/>
                <a:t>100 nM (3× dilution)</a:t>
              </a:r>
              <a:endParaRPr lang="zh-CN" altLang="en-US" sz="1200" b="1" dirty="0"/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EE1CEB01-AC48-F794-C904-6BC0CC2190C7}"/>
                </a:ext>
              </a:extLst>
            </p:cNvPr>
            <p:cNvSpPr txBox="1"/>
            <p:nvPr/>
          </p:nvSpPr>
          <p:spPr>
            <a:xfrm>
              <a:off x="6663320" y="894952"/>
              <a:ext cx="51395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/>
                <a:t>100    33.333   11.111  3.074  1.235  0.412     0.137   0.046  0.015   0.005   0.002    0.001</a:t>
              </a:r>
              <a:endParaRPr lang="zh-CN" altLang="en-US" sz="1000" b="1" dirty="0"/>
            </a:p>
          </p:txBody>
        </p:sp>
        <p:sp>
          <p:nvSpPr>
            <p:cNvPr id="15" name="TextBox 18">
              <a:extLst>
                <a:ext uri="{FF2B5EF4-FFF2-40B4-BE49-F238E27FC236}">
                  <a16:creationId xmlns:a16="http://schemas.microsoft.com/office/drawing/2014/main" id="{79EB1894-A63C-D6C6-0C2F-09D3339E85C4}"/>
                </a:ext>
              </a:extLst>
            </p:cNvPr>
            <p:cNvSpPr txBox="1"/>
            <p:nvPr/>
          </p:nvSpPr>
          <p:spPr>
            <a:xfrm>
              <a:off x="5809648" y="1005240"/>
              <a:ext cx="923755" cy="30979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ts val="29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de-DE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Isatuximab</a:t>
              </a:r>
            </a:p>
            <a:p>
              <a:pPr marL="0" marR="0" lvl="0" indent="0" algn="r" defTabSz="914400" rtl="0" eaLnBrk="1" fontAlgn="auto" latinLnBrk="0" hangingPunct="1">
                <a:lnSpc>
                  <a:spcPts val="29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lang="de-DE" altLang="zh-CN" sz="800" b="1" dirty="0">
                  <a:solidFill>
                    <a:prstClr val="black"/>
                  </a:solidFill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Daratumumab</a:t>
              </a:r>
              <a:endParaRPr kumimoji="0" lang="de-DE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/>
                <a:cs typeface="Times New Roman" panose="02020603050405020304" pitchFamily="18" charset="0"/>
              </a:endParaRPr>
            </a:p>
            <a:p>
              <a:pPr marL="0" marR="0" lvl="0" indent="0" algn="r" defTabSz="914400" rtl="0" eaLnBrk="1" fontAlgn="auto" latinLnBrk="0" hangingPunct="1">
                <a:lnSpc>
                  <a:spcPts val="29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35G5</a:t>
              </a:r>
              <a:endParaRPr kumimoji="0" lang="de-DE" altLang="zh-CN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/>
                <a:cs typeface="Times New Roman" panose="02020603050405020304" pitchFamily="18" charset="0"/>
              </a:endParaRPr>
            </a:p>
            <a:p>
              <a:pPr marL="0" marR="0" lvl="0" indent="0" algn="r" defTabSz="914400" rtl="0" eaLnBrk="1" fontAlgn="auto" latinLnBrk="0" hangingPunct="1">
                <a:lnSpc>
                  <a:spcPts val="29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de-DE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4A8</a:t>
              </a:r>
              <a:endParaRPr lang="de-DE" altLang="zh-CN" sz="800" b="1" dirty="0">
                <a:solidFill>
                  <a:prstClr val="black"/>
                </a:solidFill>
                <a:latin typeface="Times New Roman" panose="02020603050405020304" pitchFamily="18" charset="0"/>
                <a:ea typeface="微软雅黑"/>
                <a:cs typeface="Times New Roman" panose="02020603050405020304" pitchFamily="18" charset="0"/>
              </a:endParaRPr>
            </a:p>
            <a:p>
              <a:pPr marL="0" marR="0" lvl="0" indent="0" algn="r" defTabSz="914400" rtl="0" eaLnBrk="1" fontAlgn="auto" latinLnBrk="0" hangingPunct="1">
                <a:lnSpc>
                  <a:spcPts val="29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de-DE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12C10</a:t>
              </a:r>
            </a:p>
            <a:p>
              <a:pPr marL="0" marR="0" lvl="0" indent="0" algn="r" defTabSz="914400" rtl="0" eaLnBrk="1" fontAlgn="auto" latinLnBrk="0" hangingPunct="1">
                <a:lnSpc>
                  <a:spcPts val="29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de-DE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65A7</a:t>
              </a:r>
            </a:p>
            <a:p>
              <a:pPr algn="r">
                <a:lnSpc>
                  <a:spcPts val="2900"/>
                </a:lnSpc>
                <a:defRPr/>
              </a:pPr>
              <a:r>
                <a:rPr kumimoji="0" lang="de-DE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26B4</a:t>
              </a:r>
            </a:p>
            <a:p>
              <a:pPr marL="0" marR="0" lvl="0" indent="0" algn="r" defTabSz="914400" rtl="0" eaLnBrk="1" fontAlgn="auto" latinLnBrk="0" hangingPunct="1">
                <a:lnSpc>
                  <a:spcPts val="29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de-DE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Times New Roman" panose="02020603050405020304" pitchFamily="18" charset="0"/>
                  <a:ea typeface="微软雅黑"/>
                  <a:cs typeface="Times New Roman" panose="02020603050405020304" pitchFamily="18" charset="0"/>
                </a:rPr>
                <a:t>Hu5F9</a:t>
              </a: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22DD7FDA-02C5-4CFE-88CA-C50382334243}"/>
                </a:ext>
              </a:extLst>
            </p:cNvPr>
            <p:cNvSpPr/>
            <p:nvPr/>
          </p:nvSpPr>
          <p:spPr>
            <a:xfrm>
              <a:off x="6714690" y="3688425"/>
              <a:ext cx="1638200" cy="33869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n>
                  <a:solidFill>
                    <a:srgbClr val="FF0000"/>
                  </a:solidFill>
                </a:ln>
              </a:endParaRPr>
            </a:p>
          </p:txBody>
        </p:sp>
      </p:grpSp>
      <p:sp>
        <p:nvSpPr>
          <p:cNvPr id="19" name="文本框 18">
            <a:extLst>
              <a:ext uri="{FF2B5EF4-FFF2-40B4-BE49-F238E27FC236}">
                <a16:creationId xmlns:a16="http://schemas.microsoft.com/office/drawing/2014/main" id="{B99E4F5C-E377-5A5E-3F16-35ABA38BE614}"/>
              </a:ext>
            </a:extLst>
          </p:cNvPr>
          <p:cNvSpPr txBox="1"/>
          <p:nvPr/>
        </p:nvSpPr>
        <p:spPr>
          <a:xfrm>
            <a:off x="14725" y="10276"/>
            <a:ext cx="2666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6.</a:t>
            </a:r>
            <a:endParaRPr lang="zh-CN" altLang="en-US" sz="20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BDF454F-3097-5B6F-7E30-C3AA50B27821}"/>
              </a:ext>
            </a:extLst>
          </p:cNvPr>
          <p:cNvSpPr txBox="1"/>
          <p:nvPr/>
        </p:nvSpPr>
        <p:spPr>
          <a:xfrm>
            <a:off x="423826" y="3181938"/>
            <a:ext cx="4555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6C</a:t>
            </a:r>
            <a:endParaRPr lang="zh-CN" altLang="en-US" b="1" dirty="0"/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159BA0AF-AD79-D0EB-64BF-532AC54FBB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3201796"/>
              </p:ext>
            </p:extLst>
          </p:nvPr>
        </p:nvGraphicFramePr>
        <p:xfrm>
          <a:off x="417472" y="3615074"/>
          <a:ext cx="4221162" cy="2520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4861832" imgH="2858054" progId="Prism10.Document">
                  <p:embed/>
                </p:oleObj>
              </mc:Choice>
              <mc:Fallback>
                <p:oleObj name="Prism 10" r:id="rId6" imgW="4861832" imgH="2858054" progId="Prism10.Document">
                  <p:embed/>
                  <p:pic>
                    <p:nvPicPr>
                      <p:cNvPr id="2" name="对象 1">
                        <a:extLst>
                          <a:ext uri="{FF2B5EF4-FFF2-40B4-BE49-F238E27FC236}">
                            <a16:creationId xmlns:a16="http://schemas.microsoft.com/office/drawing/2014/main" id="{159BA0AF-AD79-D0EB-64BF-532AC54FBB56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7472" y="3615074"/>
                        <a:ext cx="4221162" cy="252095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noFill/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8731170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BA01CCB4-3CEE-B012-977F-73486DC6CF41}"/>
              </a:ext>
            </a:extLst>
          </p:cNvPr>
          <p:cNvSpPr txBox="1"/>
          <p:nvPr/>
        </p:nvSpPr>
        <p:spPr>
          <a:xfrm>
            <a:off x="14725" y="10276"/>
            <a:ext cx="2666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7.</a:t>
            </a:r>
            <a:endParaRPr lang="zh-CN" altLang="en-US" sz="2000" b="1" dirty="0"/>
          </a:p>
        </p:txBody>
      </p: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6DCD9006-7363-5643-CD30-4BAAE7BBF067}"/>
              </a:ext>
            </a:extLst>
          </p:cNvPr>
          <p:cNvGrpSpPr>
            <a:grpSpLocks noChangeAspect="1"/>
          </p:cNvGrpSpPr>
          <p:nvPr/>
        </p:nvGrpSpPr>
        <p:grpSpPr>
          <a:xfrm>
            <a:off x="66095" y="821930"/>
            <a:ext cx="6758636" cy="3420000"/>
            <a:chOff x="14725" y="626724"/>
            <a:chExt cx="7207881" cy="3647325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D01CFDEB-B4C8-94FE-436F-51FB665C1670}"/>
                </a:ext>
              </a:extLst>
            </p:cNvPr>
            <p:cNvGrpSpPr/>
            <p:nvPr/>
          </p:nvGrpSpPr>
          <p:grpSpPr>
            <a:xfrm>
              <a:off x="137531" y="774132"/>
              <a:ext cx="7033705" cy="3380619"/>
              <a:chOff x="158079" y="1185098"/>
              <a:chExt cx="7033705" cy="3380619"/>
            </a:xfrm>
          </p:grpSpPr>
          <p:pic>
            <p:nvPicPr>
              <p:cNvPr id="3" name="图片 2">
                <a:extLst>
                  <a:ext uri="{FF2B5EF4-FFF2-40B4-BE49-F238E27FC236}">
                    <a16:creationId xmlns:a16="http://schemas.microsoft.com/office/drawing/2014/main" id="{38E8A338-0120-83A0-4CC2-33D6E04C46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58079" y="2071971"/>
                <a:ext cx="3465956" cy="720000"/>
              </a:xfrm>
              <a:prstGeom prst="rect">
                <a:avLst/>
              </a:prstGeom>
            </p:spPr>
          </p:pic>
          <p:sp>
            <p:nvSpPr>
              <p:cNvPr id="4" name="文本框 3">
                <a:extLst>
                  <a:ext uri="{FF2B5EF4-FFF2-40B4-BE49-F238E27FC236}">
                    <a16:creationId xmlns:a16="http://schemas.microsoft.com/office/drawing/2014/main" id="{C3191B09-AA70-7FE5-3E85-D5BEA56D42B6}"/>
                  </a:ext>
                </a:extLst>
              </p:cNvPr>
              <p:cNvSpPr txBox="1"/>
              <p:nvPr/>
            </p:nvSpPr>
            <p:spPr>
              <a:xfrm>
                <a:off x="478503" y="2092519"/>
                <a:ext cx="1803922" cy="2625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FF0000"/>
                    </a:solidFill>
                  </a:rPr>
                  <a:t>IMM5605-4A8        98.52%</a:t>
                </a:r>
                <a:endParaRPr lang="zh-CN" altLang="en-US" sz="1000" b="1" dirty="0">
                  <a:solidFill>
                    <a:srgbClr val="FF0000"/>
                  </a:solidFill>
                </a:endParaRPr>
              </a:p>
            </p:txBody>
          </p:sp>
          <p:pic>
            <p:nvPicPr>
              <p:cNvPr id="6" name="图片 5" descr="图片包含 图表&#10;&#10;描述已自动生成">
                <a:extLst>
                  <a:ext uri="{FF2B5EF4-FFF2-40B4-BE49-F238E27FC236}">
                    <a16:creationId xmlns:a16="http://schemas.microsoft.com/office/drawing/2014/main" id="{A37436B5-A52D-60FC-2B0D-822121601FF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8079" y="3845717"/>
                <a:ext cx="3447617" cy="720000"/>
              </a:xfrm>
              <a:prstGeom prst="rect">
                <a:avLst/>
              </a:prstGeom>
            </p:spPr>
          </p:pic>
          <p:sp>
            <p:nvSpPr>
              <p:cNvPr id="7" name="文本框 6">
                <a:extLst>
                  <a:ext uri="{FF2B5EF4-FFF2-40B4-BE49-F238E27FC236}">
                    <a16:creationId xmlns:a16="http://schemas.microsoft.com/office/drawing/2014/main" id="{E7016EFC-B9A9-A350-41F6-5485047F62DA}"/>
                  </a:ext>
                </a:extLst>
              </p:cNvPr>
              <p:cNvSpPr txBox="1"/>
              <p:nvPr/>
            </p:nvSpPr>
            <p:spPr>
              <a:xfrm>
                <a:off x="478498" y="3863816"/>
                <a:ext cx="1879142" cy="2625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FF0000"/>
                    </a:solidFill>
                  </a:rPr>
                  <a:t>IMM5605-65A7        93.54%</a:t>
                </a:r>
                <a:endParaRPr lang="zh-CN" altLang="en-US" sz="1000" b="1" dirty="0">
                  <a:solidFill>
                    <a:srgbClr val="FF0000"/>
                  </a:solidFill>
                </a:endParaRPr>
              </a:p>
            </p:txBody>
          </p:sp>
          <p:pic>
            <p:nvPicPr>
              <p:cNvPr id="10" name="图片 9" descr="日程表&#10;&#10;描述已自动生成">
                <a:extLst>
                  <a:ext uri="{FF2B5EF4-FFF2-40B4-BE49-F238E27FC236}">
                    <a16:creationId xmlns:a16="http://schemas.microsoft.com/office/drawing/2014/main" id="{7CB508E9-337D-07EF-7BCE-4D0E461804D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3485" y="2071971"/>
                <a:ext cx="3439999" cy="720000"/>
              </a:xfrm>
              <a:prstGeom prst="rect">
                <a:avLst/>
              </a:prstGeom>
            </p:spPr>
          </p:pic>
          <p:sp>
            <p:nvSpPr>
              <p:cNvPr id="11" name="文本框 10">
                <a:extLst>
                  <a:ext uri="{FF2B5EF4-FFF2-40B4-BE49-F238E27FC236}">
                    <a16:creationId xmlns:a16="http://schemas.microsoft.com/office/drawing/2014/main" id="{A036C2D3-9B9A-2BAF-CD95-04373D76E899}"/>
                  </a:ext>
                </a:extLst>
              </p:cNvPr>
              <p:cNvSpPr txBox="1"/>
              <p:nvPr/>
            </p:nvSpPr>
            <p:spPr>
              <a:xfrm>
                <a:off x="4053909" y="2101332"/>
                <a:ext cx="1947524" cy="2625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FF0000"/>
                    </a:solidFill>
                  </a:rPr>
                  <a:t>IMM5605-12C10        92.98%</a:t>
                </a:r>
                <a:endParaRPr lang="zh-CN" altLang="en-US" sz="1000" b="1" dirty="0">
                  <a:solidFill>
                    <a:srgbClr val="FF0000"/>
                  </a:solidFill>
                </a:endParaRPr>
              </a:p>
            </p:txBody>
          </p:sp>
          <p:pic>
            <p:nvPicPr>
              <p:cNvPr id="13" name="图片 12" descr="图片包含 日程表&#10;&#10;描述已自动生成">
                <a:extLst>
                  <a:ext uri="{FF2B5EF4-FFF2-40B4-BE49-F238E27FC236}">
                    <a16:creationId xmlns:a16="http://schemas.microsoft.com/office/drawing/2014/main" id="{835F7D8E-BD70-EBEC-D693-CC5276543D5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8079" y="2958844"/>
                <a:ext cx="3458299" cy="720000"/>
              </a:xfrm>
              <a:prstGeom prst="rect">
                <a:avLst/>
              </a:prstGeom>
            </p:spPr>
          </p:pic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C1043269-1911-EB90-25DD-CE91DBD6A33A}"/>
                  </a:ext>
                </a:extLst>
              </p:cNvPr>
              <p:cNvSpPr txBox="1"/>
              <p:nvPr/>
            </p:nvSpPr>
            <p:spPr>
              <a:xfrm>
                <a:off x="478497" y="2970579"/>
                <a:ext cx="1868885" cy="2625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FF0000"/>
                    </a:solidFill>
                  </a:rPr>
                  <a:t>IMM5605-26B4        97.66%</a:t>
                </a:r>
                <a:endParaRPr lang="zh-CN" altLang="en-US" sz="1000" b="1" dirty="0">
                  <a:solidFill>
                    <a:srgbClr val="FF0000"/>
                  </a:solidFill>
                </a:endParaRPr>
              </a:p>
            </p:txBody>
          </p:sp>
          <p:pic>
            <p:nvPicPr>
              <p:cNvPr id="16" name="图片 15" descr="图片包含 图形用户界面&#10;&#10;描述已自动生成">
                <a:extLst>
                  <a:ext uri="{FF2B5EF4-FFF2-40B4-BE49-F238E27FC236}">
                    <a16:creationId xmlns:a16="http://schemas.microsoft.com/office/drawing/2014/main" id="{8BEDA572-C046-5D08-4161-4B17283282E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3485" y="2958844"/>
                <a:ext cx="3458299" cy="720000"/>
              </a:xfrm>
              <a:prstGeom prst="rect">
                <a:avLst/>
              </a:prstGeom>
            </p:spPr>
          </p:pic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F4A8B2DB-8342-71BF-3420-C63F1FF558A9}"/>
                  </a:ext>
                </a:extLst>
              </p:cNvPr>
              <p:cNvSpPr txBox="1"/>
              <p:nvPr/>
            </p:nvSpPr>
            <p:spPr>
              <a:xfrm>
                <a:off x="4049676" y="2973028"/>
                <a:ext cx="17652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FF0000"/>
                    </a:solidFill>
                  </a:rPr>
                  <a:t>IMM5605-35G5        98.64%</a:t>
                </a:r>
                <a:endParaRPr lang="zh-CN" altLang="en-US" sz="1000" b="1" dirty="0">
                  <a:solidFill>
                    <a:srgbClr val="FF0000"/>
                  </a:solidFill>
                </a:endParaRPr>
              </a:p>
            </p:txBody>
          </p:sp>
          <p:pic>
            <p:nvPicPr>
              <p:cNvPr id="19" name="图片 18" descr="图片包含 图形用户界面&#10;&#10;描述已自动生成">
                <a:extLst>
                  <a:ext uri="{FF2B5EF4-FFF2-40B4-BE49-F238E27FC236}">
                    <a16:creationId xmlns:a16="http://schemas.microsoft.com/office/drawing/2014/main" id="{9636019F-4CE2-74E4-0C1D-AC9E8951C43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8079" y="1185098"/>
                <a:ext cx="3458299" cy="720000"/>
              </a:xfrm>
              <a:prstGeom prst="rect">
                <a:avLst/>
              </a:prstGeom>
            </p:spPr>
          </p:pic>
          <p:sp>
            <p:nvSpPr>
              <p:cNvPr id="20" name="文本框 19">
                <a:extLst>
                  <a:ext uri="{FF2B5EF4-FFF2-40B4-BE49-F238E27FC236}">
                    <a16:creationId xmlns:a16="http://schemas.microsoft.com/office/drawing/2014/main" id="{C450A855-3831-583D-B8A7-F571F736EE5D}"/>
                  </a:ext>
                </a:extLst>
              </p:cNvPr>
              <p:cNvSpPr txBox="1"/>
              <p:nvPr/>
            </p:nvSpPr>
            <p:spPr>
              <a:xfrm>
                <a:off x="488285" y="1207845"/>
                <a:ext cx="1928719" cy="2625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FF0000"/>
                    </a:solidFill>
                  </a:rPr>
                  <a:t>IMM5605-DARA        97.05%</a:t>
                </a:r>
                <a:endParaRPr lang="zh-CN" altLang="en-US" sz="1000" b="1" dirty="0">
                  <a:solidFill>
                    <a:srgbClr val="FF0000"/>
                  </a:solidFill>
                </a:endParaRPr>
              </a:p>
            </p:txBody>
          </p:sp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05C51CEF-7BC5-3F44-D790-008772444B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3485" y="1185098"/>
                <a:ext cx="3439999" cy="720000"/>
              </a:xfrm>
              <a:prstGeom prst="rect">
                <a:avLst/>
              </a:prstGeom>
            </p:spPr>
          </p:pic>
          <p:sp>
            <p:nvSpPr>
              <p:cNvPr id="23" name="文本框 22">
                <a:extLst>
                  <a:ext uri="{FF2B5EF4-FFF2-40B4-BE49-F238E27FC236}">
                    <a16:creationId xmlns:a16="http://schemas.microsoft.com/office/drawing/2014/main" id="{1F5CB0AA-405D-B8D2-0FFE-6221CC667B1F}"/>
                  </a:ext>
                </a:extLst>
              </p:cNvPr>
              <p:cNvSpPr txBox="1"/>
              <p:nvPr/>
            </p:nvSpPr>
            <p:spPr>
              <a:xfrm>
                <a:off x="4053422" y="1203202"/>
                <a:ext cx="1768021" cy="26258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FF0000"/>
                    </a:solidFill>
                  </a:rPr>
                  <a:t>IMM5605-ISA        95.64%</a:t>
                </a:r>
                <a:endParaRPr lang="zh-CN" altLang="en-US" sz="1000" b="1" dirty="0">
                  <a:solidFill>
                    <a:srgbClr val="FF0000"/>
                  </a:solidFill>
                </a:endParaRPr>
              </a:p>
            </p:txBody>
          </p:sp>
        </p:grp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A702D00C-5A5C-E36B-ED51-BD6496F4C029}"/>
                </a:ext>
              </a:extLst>
            </p:cNvPr>
            <p:cNvSpPr/>
            <p:nvPr/>
          </p:nvSpPr>
          <p:spPr>
            <a:xfrm>
              <a:off x="14725" y="626724"/>
              <a:ext cx="7207881" cy="3647325"/>
            </a:xfrm>
            <a:prstGeom prst="rect">
              <a:avLst/>
            </a:prstGeom>
            <a:noFill/>
            <a:ln w="19050"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5F4BB657-6CB0-7604-F918-6E9E6A8B10F1}"/>
              </a:ext>
            </a:extLst>
          </p:cNvPr>
          <p:cNvGrpSpPr/>
          <p:nvPr/>
        </p:nvGrpSpPr>
        <p:grpSpPr>
          <a:xfrm>
            <a:off x="6893442" y="826200"/>
            <a:ext cx="5189229" cy="3430894"/>
            <a:chOff x="6893442" y="826200"/>
            <a:chExt cx="5189229" cy="3430894"/>
          </a:xfrm>
        </p:grpSpPr>
        <p:grpSp>
          <p:nvGrpSpPr>
            <p:cNvPr id="24" name="组合 23">
              <a:extLst>
                <a:ext uri="{FF2B5EF4-FFF2-40B4-BE49-F238E27FC236}">
                  <a16:creationId xmlns:a16="http://schemas.microsoft.com/office/drawing/2014/main" id="{9C776AC0-4E2D-B1D1-9237-1C098EFFE44F}"/>
                </a:ext>
              </a:extLst>
            </p:cNvPr>
            <p:cNvGrpSpPr/>
            <p:nvPr/>
          </p:nvGrpSpPr>
          <p:grpSpPr>
            <a:xfrm>
              <a:off x="6893442" y="968206"/>
              <a:ext cx="5189229" cy="3288888"/>
              <a:chOff x="6630033" y="3498524"/>
              <a:chExt cx="4997430" cy="3167328"/>
            </a:xfrm>
          </p:grpSpPr>
          <p:pic>
            <p:nvPicPr>
              <p:cNvPr id="12" name="图片 11" descr="微信图片_20231026132211">
                <a:extLst>
                  <a:ext uri="{FF2B5EF4-FFF2-40B4-BE49-F238E27FC236}">
                    <a16:creationId xmlns:a16="http://schemas.microsoft.com/office/drawing/2014/main" id="{3224B985-67A3-E889-26D2-49D27A33BE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lum bright="30000" contrast="48000"/>
              </a:blip>
              <a:srcRect l="27577" t="45792" r="16388" b="24800"/>
              <a:stretch>
                <a:fillRect/>
              </a:stretch>
            </p:blipFill>
            <p:spPr>
              <a:xfrm rot="5400000">
                <a:off x="7783747" y="2841504"/>
                <a:ext cx="2893695" cy="4608830"/>
              </a:xfrm>
              <a:prstGeom prst="rect">
                <a:avLst/>
              </a:prstGeom>
            </p:spPr>
          </p:pic>
          <p:sp>
            <p:nvSpPr>
              <p:cNvPr id="21" name="文本框 20">
                <a:extLst>
                  <a:ext uri="{FF2B5EF4-FFF2-40B4-BE49-F238E27FC236}">
                    <a16:creationId xmlns:a16="http://schemas.microsoft.com/office/drawing/2014/main" id="{34B331F8-DE8B-E41C-B7D8-0E857CD85454}"/>
                  </a:ext>
                </a:extLst>
              </p:cNvPr>
              <p:cNvSpPr txBox="1"/>
              <p:nvPr/>
            </p:nvSpPr>
            <p:spPr>
              <a:xfrm>
                <a:off x="6630033" y="3731484"/>
                <a:ext cx="344566" cy="29343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800" b="1" dirty="0"/>
                  <a:t>180</a:t>
                </a:r>
              </a:p>
              <a:p>
                <a:endParaRPr lang="en-US" altLang="zh-CN" sz="800" b="1" dirty="0"/>
              </a:p>
              <a:p>
                <a:r>
                  <a:rPr lang="en-US" altLang="zh-CN" sz="800" b="1" dirty="0"/>
                  <a:t>130</a:t>
                </a:r>
              </a:p>
              <a:p>
                <a:endParaRPr lang="en-US" altLang="zh-CN" sz="800" b="1" dirty="0"/>
              </a:p>
              <a:p>
                <a:endParaRPr lang="en-US" altLang="zh-CN" sz="800" b="1" dirty="0"/>
              </a:p>
              <a:p>
                <a:r>
                  <a:rPr lang="en-US" altLang="zh-CN" sz="800" b="1" dirty="0"/>
                  <a:t>100</a:t>
                </a:r>
              </a:p>
              <a:p>
                <a:endParaRPr lang="en-US" altLang="zh-CN" sz="800" b="1" dirty="0"/>
              </a:p>
              <a:p>
                <a:endParaRPr lang="en-US" altLang="zh-CN" sz="800" b="1" dirty="0"/>
              </a:p>
              <a:p>
                <a:r>
                  <a:rPr lang="en-US" altLang="zh-CN" sz="800" b="1" dirty="0"/>
                  <a:t>70</a:t>
                </a:r>
              </a:p>
              <a:p>
                <a:r>
                  <a:rPr lang="en-US" altLang="zh-CN" sz="800" b="1" dirty="0"/>
                  <a:t>55</a:t>
                </a:r>
              </a:p>
              <a:p>
                <a:endParaRPr lang="en-US" altLang="zh-CN" sz="800" b="1" dirty="0"/>
              </a:p>
              <a:p>
                <a:endParaRPr lang="en-US" altLang="zh-CN" sz="800" b="1" dirty="0"/>
              </a:p>
              <a:p>
                <a:r>
                  <a:rPr lang="en-US" altLang="zh-CN" sz="800" b="1" dirty="0"/>
                  <a:t>40</a:t>
                </a:r>
              </a:p>
              <a:p>
                <a:endParaRPr lang="en-US" altLang="zh-CN" sz="800" b="1" dirty="0"/>
              </a:p>
              <a:p>
                <a:endParaRPr lang="en-US" altLang="zh-CN" sz="800" b="1" dirty="0"/>
              </a:p>
              <a:p>
                <a:r>
                  <a:rPr lang="en-US" altLang="zh-CN" sz="800" b="1" dirty="0"/>
                  <a:t>35</a:t>
                </a:r>
              </a:p>
              <a:p>
                <a:endParaRPr lang="en-US" altLang="zh-CN" sz="800" b="1" dirty="0"/>
              </a:p>
              <a:p>
                <a:r>
                  <a:rPr lang="en-US" altLang="zh-CN" sz="800" b="1" dirty="0"/>
                  <a:t>25</a:t>
                </a:r>
              </a:p>
              <a:p>
                <a:endParaRPr lang="en-US" altLang="zh-CN" sz="800" b="1" dirty="0"/>
              </a:p>
              <a:p>
                <a:endParaRPr lang="en-US" altLang="zh-CN" sz="800" b="1" dirty="0"/>
              </a:p>
              <a:p>
                <a:endParaRPr lang="en-US" altLang="zh-CN" sz="800" b="1" dirty="0"/>
              </a:p>
              <a:p>
                <a:r>
                  <a:rPr lang="en-US" altLang="zh-CN" sz="800" b="1" dirty="0"/>
                  <a:t>15</a:t>
                </a:r>
              </a:p>
              <a:p>
                <a:endParaRPr lang="en-US" altLang="zh-CN" sz="800" b="1" dirty="0"/>
              </a:p>
              <a:p>
                <a:r>
                  <a:rPr lang="en-US" altLang="zh-CN" sz="800" b="1" dirty="0"/>
                  <a:t>10</a:t>
                </a:r>
                <a:endParaRPr lang="zh-CN" altLang="en-US" sz="800" b="1" dirty="0"/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32BC8DD9-5D17-A705-F1CD-765D9794AD0A}"/>
                  </a:ext>
                </a:extLst>
              </p:cNvPr>
              <p:cNvSpPr txBox="1"/>
              <p:nvPr/>
            </p:nvSpPr>
            <p:spPr>
              <a:xfrm>
                <a:off x="6904427" y="3498524"/>
                <a:ext cx="4723036" cy="385322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lstStyle/>
              <a:p>
                <a:pPr eaLnBrk="0" fontAlgn="ctr" hangingPunct="0"/>
                <a:r>
                  <a:rPr lang="en-US" altLang="pt-BR" sz="1000" dirty="0">
                    <a:latin typeface="Times New Roman" panose="02020603050405020304" pitchFamily="18" charset="0"/>
                    <a:sym typeface="+mn-ea"/>
                  </a:rPr>
                  <a:t>Marker    </a:t>
                </a:r>
                <a:r>
                  <a:rPr lang="en-US" altLang="pt-BR" sz="1000" u="sng" dirty="0">
                    <a:latin typeface="Times New Roman" panose="02020603050405020304" pitchFamily="18" charset="0"/>
                    <a:sym typeface="+mn-ea"/>
                  </a:rPr>
                  <a:t>                                                   IMM5605                                                           </a:t>
                </a:r>
                <a:r>
                  <a:rPr lang="en-US" altLang="pt-BR" sz="1000" u="sng" dirty="0">
                    <a:solidFill>
                      <a:schemeClr val="bg1"/>
                    </a:solidFill>
                    <a:latin typeface="Times New Roman" panose="02020603050405020304" pitchFamily="18" charset="0"/>
                    <a:sym typeface="+mn-ea"/>
                  </a:rPr>
                  <a:t>1</a:t>
                </a:r>
                <a:r>
                  <a:rPr lang="en-US" altLang="pt-BR" sz="1000" u="sng" dirty="0">
                    <a:latin typeface="Times New Roman" panose="02020603050405020304" pitchFamily="18" charset="0"/>
                    <a:sym typeface="+mn-ea"/>
                  </a:rPr>
                  <a:t>    </a:t>
                </a:r>
              </a:p>
              <a:p>
                <a:pPr eaLnBrk="0" fontAlgn="ctr" hangingPunct="0"/>
                <a:r>
                  <a:rPr lang="en-US" altLang="pt-BR" sz="1000" dirty="0">
                    <a:latin typeface="Times New Roman" panose="02020603050405020304" pitchFamily="18" charset="0"/>
                    <a:sym typeface="+mn-ea"/>
                  </a:rPr>
                  <a:t>                    ISA           DARA        4A8         12C10         26B4         35G5         65A7 </a:t>
                </a:r>
              </a:p>
            </p:txBody>
          </p:sp>
        </p:grp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D6CD1583-DB2F-4375-120F-69763762204A}"/>
                </a:ext>
              </a:extLst>
            </p:cNvPr>
            <p:cNvSpPr/>
            <p:nvPr/>
          </p:nvSpPr>
          <p:spPr>
            <a:xfrm>
              <a:off x="6923335" y="826200"/>
              <a:ext cx="5159336" cy="3420000"/>
            </a:xfrm>
            <a:prstGeom prst="rect">
              <a:avLst/>
            </a:prstGeom>
            <a:noFill/>
            <a:ln w="19050">
              <a:solidFill>
                <a:schemeClr val="accent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  <p:sp>
        <p:nvSpPr>
          <p:cNvPr id="29" name="文本框 28">
            <a:extLst>
              <a:ext uri="{FF2B5EF4-FFF2-40B4-BE49-F238E27FC236}">
                <a16:creationId xmlns:a16="http://schemas.microsoft.com/office/drawing/2014/main" id="{9E4CD3CB-1DBF-5364-255F-20D392A7AF50}"/>
              </a:ext>
            </a:extLst>
          </p:cNvPr>
          <p:cNvSpPr txBox="1"/>
          <p:nvPr/>
        </p:nvSpPr>
        <p:spPr>
          <a:xfrm>
            <a:off x="53627" y="413795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7A</a:t>
            </a:r>
            <a:endParaRPr lang="zh-CN" altLang="en-US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994E510-B031-88D6-6B04-ECE7752E3B88}"/>
              </a:ext>
            </a:extLst>
          </p:cNvPr>
          <p:cNvSpPr txBox="1"/>
          <p:nvPr/>
        </p:nvSpPr>
        <p:spPr>
          <a:xfrm>
            <a:off x="6939804" y="41379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7B</a:t>
            </a:r>
            <a:endParaRPr lang="zh-CN" altLang="en-US" b="1" dirty="0">
              <a:highlight>
                <a:srgbClr val="FFFF00"/>
              </a:highlight>
            </a:endParaRPr>
          </a:p>
        </p:txBody>
      </p:sp>
    </p:spTree>
    <p:extLst>
      <p:ext uri="{BB962C8B-B14F-4D97-AF65-F5344CB8AC3E}">
        <p14:creationId xmlns:p14="http://schemas.microsoft.com/office/powerpoint/2010/main" val="22414907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图片 23">
            <a:extLst>
              <a:ext uri="{FF2B5EF4-FFF2-40B4-BE49-F238E27FC236}">
                <a16:creationId xmlns:a16="http://schemas.microsoft.com/office/drawing/2014/main" id="{00000000-0008-0000-0C00-0000090000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37756" y="2523815"/>
            <a:ext cx="2533371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00000000-0008-0000-0C00-0000080000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11661" y="2529000"/>
            <a:ext cx="2533371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00000000-0008-0000-0C00-0000060000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8303" y="2523815"/>
            <a:ext cx="2533371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0000000-0008-0000-0C00-0000050000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12006" y="554054"/>
            <a:ext cx="2533371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00000000-0008-0000-0C00-00000400000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237756" y="554054"/>
            <a:ext cx="2533371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0000000-0008-0000-0C00-00000300000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88205" y="554054"/>
            <a:ext cx="2533371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00000000-0008-0000-0C00-00000200000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8303" y="557914"/>
            <a:ext cx="2533371" cy="1800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A01CCB4-3CEE-B012-977F-73486DC6CF41}"/>
              </a:ext>
            </a:extLst>
          </p:cNvPr>
          <p:cNvSpPr txBox="1"/>
          <p:nvPr/>
        </p:nvSpPr>
        <p:spPr>
          <a:xfrm>
            <a:off x="14725" y="10276"/>
            <a:ext cx="2666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8.</a:t>
            </a:r>
            <a:endParaRPr lang="zh-CN" altLang="en-US" sz="20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52CFCA1-331E-364D-7C6F-2B2E1520DEA6}"/>
              </a:ext>
            </a:extLst>
          </p:cNvPr>
          <p:cNvSpPr txBox="1"/>
          <p:nvPr/>
        </p:nvSpPr>
        <p:spPr>
          <a:xfrm>
            <a:off x="1423418" y="1924375"/>
            <a:ext cx="1343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DARA</a:t>
            </a:r>
            <a:endParaRPr lang="zh-CN" altLang="en-US" sz="12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9A4989B-56E4-CF0F-89FC-E691A3FF1E0E}"/>
              </a:ext>
            </a:extLst>
          </p:cNvPr>
          <p:cNvSpPr txBox="1"/>
          <p:nvPr/>
        </p:nvSpPr>
        <p:spPr>
          <a:xfrm>
            <a:off x="3968326" y="1911869"/>
            <a:ext cx="1162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ISA</a:t>
            </a:r>
            <a:endParaRPr lang="zh-CN" altLang="en-US" sz="12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82B22C2-B848-AB18-0849-94548E26D4DD}"/>
              </a:ext>
            </a:extLst>
          </p:cNvPr>
          <p:cNvSpPr txBox="1"/>
          <p:nvPr/>
        </p:nvSpPr>
        <p:spPr>
          <a:xfrm>
            <a:off x="6527959" y="1907406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4A8</a:t>
            </a:r>
            <a:endParaRPr lang="zh-CN" altLang="en-US" sz="1200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FB0A237F-50D8-95CB-530D-E7E3F5C0926D}"/>
              </a:ext>
            </a:extLst>
          </p:cNvPr>
          <p:cNvSpPr txBox="1"/>
          <p:nvPr/>
        </p:nvSpPr>
        <p:spPr>
          <a:xfrm>
            <a:off x="9083141" y="1894900"/>
            <a:ext cx="13676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12C10</a:t>
            </a:r>
            <a:endParaRPr lang="zh-CN" altLang="en-US" sz="1200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5458192-679D-659D-5843-3B0C699A00AB}"/>
              </a:ext>
            </a:extLst>
          </p:cNvPr>
          <p:cNvSpPr txBox="1"/>
          <p:nvPr/>
        </p:nvSpPr>
        <p:spPr>
          <a:xfrm>
            <a:off x="1423418" y="3873194"/>
            <a:ext cx="1279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26B4</a:t>
            </a:r>
            <a:endParaRPr lang="zh-CN" altLang="en-US" sz="1200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3971F80-49D0-9D1C-01B4-9D06AA09BA3A}"/>
              </a:ext>
            </a:extLst>
          </p:cNvPr>
          <p:cNvSpPr txBox="1"/>
          <p:nvPr/>
        </p:nvSpPr>
        <p:spPr>
          <a:xfrm>
            <a:off x="3968326" y="3860688"/>
            <a:ext cx="12939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35G5</a:t>
            </a:r>
            <a:endParaRPr lang="zh-CN" altLang="en-US" sz="12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FF04B72-8CA4-F948-549D-7CD22871EDCF}"/>
              </a:ext>
            </a:extLst>
          </p:cNvPr>
          <p:cNvSpPr txBox="1"/>
          <p:nvPr/>
        </p:nvSpPr>
        <p:spPr>
          <a:xfrm>
            <a:off x="6527959" y="3856225"/>
            <a:ext cx="1289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65A7</a:t>
            </a:r>
            <a:endParaRPr lang="zh-CN" altLang="en-US" sz="1200" b="1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00000000-0008-0000-0C00-00000A00000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812006" y="2523815"/>
            <a:ext cx="2533371" cy="1800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E80C6809-84C9-641B-8936-336DF5FF237F}"/>
              </a:ext>
            </a:extLst>
          </p:cNvPr>
          <p:cNvSpPr txBox="1"/>
          <p:nvPr/>
        </p:nvSpPr>
        <p:spPr>
          <a:xfrm>
            <a:off x="9088186" y="3856224"/>
            <a:ext cx="684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01</a:t>
            </a:r>
            <a:endParaRPr lang="zh-CN" altLang="en-US" sz="1200" b="1" dirty="0"/>
          </a:p>
        </p:txBody>
      </p:sp>
      <p:graphicFrame>
        <p:nvGraphicFramePr>
          <p:cNvPr id="27" name="表格 26">
            <a:extLst>
              <a:ext uri="{FF2B5EF4-FFF2-40B4-BE49-F238E27FC236}">
                <a16:creationId xmlns:a16="http://schemas.microsoft.com/office/drawing/2014/main" id="{196A9156-8AD1-65BD-49F4-9DF33C9F2D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7424424"/>
              </p:ext>
            </p:extLst>
          </p:nvPr>
        </p:nvGraphicFramePr>
        <p:xfrm>
          <a:off x="239042" y="4498761"/>
          <a:ext cx="7341972" cy="15659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32761">
                  <a:extLst>
                    <a:ext uri="{9D8B030D-6E8A-4147-A177-3AD203B41FA5}">
                      <a16:colId xmlns:a16="http://schemas.microsoft.com/office/drawing/2014/main" val="959185836"/>
                    </a:ext>
                  </a:extLst>
                </a:gridCol>
                <a:gridCol w="881037">
                  <a:extLst>
                    <a:ext uri="{9D8B030D-6E8A-4147-A177-3AD203B41FA5}">
                      <a16:colId xmlns:a16="http://schemas.microsoft.com/office/drawing/2014/main" val="2858444821"/>
                    </a:ext>
                  </a:extLst>
                </a:gridCol>
                <a:gridCol w="797129">
                  <a:extLst>
                    <a:ext uri="{9D8B030D-6E8A-4147-A177-3AD203B41FA5}">
                      <a16:colId xmlns:a16="http://schemas.microsoft.com/office/drawing/2014/main" val="501150444"/>
                    </a:ext>
                  </a:extLst>
                </a:gridCol>
                <a:gridCol w="964945">
                  <a:extLst>
                    <a:ext uri="{9D8B030D-6E8A-4147-A177-3AD203B41FA5}">
                      <a16:colId xmlns:a16="http://schemas.microsoft.com/office/drawing/2014/main" val="3986011565"/>
                    </a:ext>
                  </a:extLst>
                </a:gridCol>
                <a:gridCol w="713220">
                  <a:extLst>
                    <a:ext uri="{9D8B030D-6E8A-4147-A177-3AD203B41FA5}">
                      <a16:colId xmlns:a16="http://schemas.microsoft.com/office/drawing/2014/main" val="2022331898"/>
                    </a:ext>
                  </a:extLst>
                </a:gridCol>
                <a:gridCol w="1216669">
                  <a:extLst>
                    <a:ext uri="{9D8B030D-6E8A-4147-A177-3AD203B41FA5}">
                      <a16:colId xmlns:a16="http://schemas.microsoft.com/office/drawing/2014/main" val="1964108911"/>
                    </a:ext>
                  </a:extLst>
                </a:gridCol>
                <a:gridCol w="964945">
                  <a:extLst>
                    <a:ext uri="{9D8B030D-6E8A-4147-A177-3AD203B41FA5}">
                      <a16:colId xmlns:a16="http://schemas.microsoft.com/office/drawing/2014/main" val="246357362"/>
                    </a:ext>
                  </a:extLst>
                </a:gridCol>
                <a:gridCol w="671266">
                  <a:extLst>
                    <a:ext uri="{9D8B030D-6E8A-4147-A177-3AD203B41FA5}">
                      <a16:colId xmlns:a16="http://schemas.microsoft.com/office/drawing/2014/main" val="2404178085"/>
                    </a:ext>
                  </a:extLst>
                </a:gridCol>
              </a:tblGrid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Loading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koff(1/s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kon(1/Ms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KD(M)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Respon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Loading Heigh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ssocia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Full R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92010395"/>
                  </a:ext>
                </a:extLst>
              </a:tr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DARA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.21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64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solidFill>
                            <a:srgbClr val="FF0000"/>
                          </a:solidFill>
                          <a:effectLst/>
                        </a:rPr>
                        <a:t>4.39E-008</a:t>
                      </a:r>
                      <a:endParaRPr lang="en-US" sz="1100" b="0" i="0" u="none" strike="noStrike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26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98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38-H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9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721193709"/>
                  </a:ext>
                </a:extLst>
              </a:tr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ISA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.58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9.32E+00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2.77E-008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06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0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38-H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9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7246937"/>
                  </a:ext>
                </a:extLst>
              </a:tr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4A8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&lt;1.00E-0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26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04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87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38-H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9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36658182"/>
                  </a:ext>
                </a:extLst>
              </a:tr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12C10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&lt;1.00E-0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.87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5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0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38-H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9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993615690"/>
                  </a:ext>
                </a:extLst>
              </a:tr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26B4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&lt;1.00E-0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.30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30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1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38-H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9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968995822"/>
                  </a:ext>
                </a:extLst>
              </a:tr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35G5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&lt;1.00E-00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.93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&lt; 1.00E-012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79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4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38-H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8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200947474"/>
                  </a:ext>
                </a:extLst>
              </a:tr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65A7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.20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.65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2.71E-008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05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98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38-H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9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28166657"/>
                  </a:ext>
                </a:extLst>
              </a:tr>
              <a:tr h="1073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01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/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/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/</a:t>
                      </a:r>
                      <a:endParaRPr lang="en-US" altLang="zh-CN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068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53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38-Hi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0.968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9262115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2154402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2" name="图片 41">
            <a:extLst>
              <a:ext uri="{FF2B5EF4-FFF2-40B4-BE49-F238E27FC236}">
                <a16:creationId xmlns:a16="http://schemas.microsoft.com/office/drawing/2014/main" id="{00000000-0008-0000-0C00-00000A0000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441323" y="2633032"/>
            <a:ext cx="2579433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00000000-0008-0000-0C00-0000080000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89926" y="2633032"/>
            <a:ext cx="2579433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00000000-0008-0000-0C00-0000070000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38145" y="2633032"/>
            <a:ext cx="2579433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00000000-0008-0000-0C00-0000060000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6365" y="2633032"/>
            <a:ext cx="2579433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00000000-0008-0000-0C00-00000500000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441706" y="621709"/>
            <a:ext cx="2579433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7" name="图片 36">
            <a:extLst>
              <a:ext uri="{FF2B5EF4-FFF2-40B4-BE49-F238E27FC236}">
                <a16:creationId xmlns:a16="http://schemas.microsoft.com/office/drawing/2014/main" id="{00000000-0008-0000-0C00-00000400000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89926" y="622697"/>
            <a:ext cx="2579433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00000000-0008-0000-0C00-00000300000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938146" y="621709"/>
            <a:ext cx="2579433" cy="1800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00000000-0008-0000-0C00-00000200000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6366" y="621709"/>
            <a:ext cx="2579433" cy="1800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BA01CCB4-3CEE-B012-977F-73486DC6CF41}"/>
              </a:ext>
            </a:extLst>
          </p:cNvPr>
          <p:cNvSpPr txBox="1"/>
          <p:nvPr/>
        </p:nvSpPr>
        <p:spPr>
          <a:xfrm>
            <a:off x="14725" y="10276"/>
            <a:ext cx="26661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000" b="1" dirty="0"/>
              <a:t>Supplement Figure 9.</a:t>
            </a:r>
            <a:endParaRPr lang="zh-CN" altLang="en-US" sz="2000" b="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253E261-78AB-C7A4-39BF-C835F4BCFA33}"/>
              </a:ext>
            </a:extLst>
          </p:cNvPr>
          <p:cNvSpPr txBox="1"/>
          <p:nvPr/>
        </p:nvSpPr>
        <p:spPr>
          <a:xfrm>
            <a:off x="1468328" y="1986019"/>
            <a:ext cx="1343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DARA</a:t>
            </a:r>
            <a:endParaRPr lang="zh-CN" altLang="en-US" sz="1200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6296455-4AD4-7AC9-7B35-8A454DFCA6FE}"/>
              </a:ext>
            </a:extLst>
          </p:cNvPr>
          <p:cNvSpPr txBox="1"/>
          <p:nvPr/>
        </p:nvSpPr>
        <p:spPr>
          <a:xfrm>
            <a:off x="4226971" y="1973513"/>
            <a:ext cx="1162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ISA</a:t>
            </a:r>
            <a:endParaRPr lang="zh-CN" altLang="en-US" sz="1200" b="1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8C1756B-9F22-E96F-45EF-D7ECFF92A4ED}"/>
              </a:ext>
            </a:extLst>
          </p:cNvPr>
          <p:cNvSpPr txBox="1"/>
          <p:nvPr/>
        </p:nvSpPr>
        <p:spPr>
          <a:xfrm>
            <a:off x="6979426" y="1969050"/>
            <a:ext cx="1204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4A8</a:t>
            </a:r>
            <a:endParaRPr lang="zh-CN" altLang="en-US" sz="1200" b="1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D4E18A86-5586-9EF3-1F49-11711114B364}"/>
              </a:ext>
            </a:extLst>
          </p:cNvPr>
          <p:cNvSpPr txBox="1"/>
          <p:nvPr/>
        </p:nvSpPr>
        <p:spPr>
          <a:xfrm>
            <a:off x="9727428" y="1956544"/>
            <a:ext cx="13676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12C10</a:t>
            </a:r>
            <a:endParaRPr lang="zh-CN" altLang="en-US" sz="1200" b="1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197A49F-FB1F-E3DD-07A6-BA9E1776BB90}"/>
              </a:ext>
            </a:extLst>
          </p:cNvPr>
          <p:cNvSpPr txBox="1"/>
          <p:nvPr/>
        </p:nvSpPr>
        <p:spPr>
          <a:xfrm>
            <a:off x="1464514" y="3986208"/>
            <a:ext cx="12795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26B4</a:t>
            </a:r>
            <a:endParaRPr lang="zh-CN" altLang="en-US" sz="1200" b="1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77162B42-5FD9-F57B-5918-C4F4F3EB9B56}"/>
              </a:ext>
            </a:extLst>
          </p:cNvPr>
          <p:cNvSpPr txBox="1"/>
          <p:nvPr/>
        </p:nvSpPr>
        <p:spPr>
          <a:xfrm>
            <a:off x="4225177" y="3973702"/>
            <a:ext cx="12939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35G5</a:t>
            </a:r>
            <a:endParaRPr lang="zh-CN" altLang="en-US" sz="1200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37B3DDD0-B0C8-F3B0-A8ED-25FF73986290}"/>
              </a:ext>
            </a:extLst>
          </p:cNvPr>
          <p:cNvSpPr txBox="1"/>
          <p:nvPr/>
        </p:nvSpPr>
        <p:spPr>
          <a:xfrm>
            <a:off x="6980015" y="3979513"/>
            <a:ext cx="12891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5605-65A7</a:t>
            </a:r>
            <a:endParaRPr lang="zh-CN" altLang="en-US" sz="1200" b="1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6541D38-5043-187B-500C-469C68A85103}"/>
              </a:ext>
            </a:extLst>
          </p:cNvPr>
          <p:cNvSpPr txBox="1"/>
          <p:nvPr/>
        </p:nvSpPr>
        <p:spPr>
          <a:xfrm>
            <a:off x="9717153" y="3986208"/>
            <a:ext cx="684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IMM01</a:t>
            </a:r>
            <a:endParaRPr lang="zh-CN" altLang="en-US" sz="1200" b="1" dirty="0"/>
          </a:p>
        </p:txBody>
      </p:sp>
      <p:graphicFrame>
        <p:nvGraphicFramePr>
          <p:cNvPr id="43" name="表格 42">
            <a:extLst>
              <a:ext uri="{FF2B5EF4-FFF2-40B4-BE49-F238E27FC236}">
                <a16:creationId xmlns:a16="http://schemas.microsoft.com/office/drawing/2014/main" id="{9BC77263-833D-76F4-564F-173593B01A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7894709"/>
              </p:ext>
            </p:extLst>
          </p:nvPr>
        </p:nvGraphicFramePr>
        <p:xfrm>
          <a:off x="186365" y="4643367"/>
          <a:ext cx="7506356" cy="15659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06379">
                  <a:extLst>
                    <a:ext uri="{9D8B030D-6E8A-4147-A177-3AD203B41FA5}">
                      <a16:colId xmlns:a16="http://schemas.microsoft.com/office/drawing/2014/main" val="1637701408"/>
                    </a:ext>
                  </a:extLst>
                </a:gridCol>
                <a:gridCol w="848933">
                  <a:extLst>
                    <a:ext uri="{9D8B030D-6E8A-4147-A177-3AD203B41FA5}">
                      <a16:colId xmlns:a16="http://schemas.microsoft.com/office/drawing/2014/main" val="3591164396"/>
                    </a:ext>
                  </a:extLst>
                </a:gridCol>
                <a:gridCol w="848933">
                  <a:extLst>
                    <a:ext uri="{9D8B030D-6E8A-4147-A177-3AD203B41FA5}">
                      <a16:colId xmlns:a16="http://schemas.microsoft.com/office/drawing/2014/main" val="1636217019"/>
                    </a:ext>
                  </a:extLst>
                </a:gridCol>
                <a:gridCol w="848933">
                  <a:extLst>
                    <a:ext uri="{9D8B030D-6E8A-4147-A177-3AD203B41FA5}">
                      <a16:colId xmlns:a16="http://schemas.microsoft.com/office/drawing/2014/main" val="2328677986"/>
                    </a:ext>
                  </a:extLst>
                </a:gridCol>
                <a:gridCol w="714891">
                  <a:extLst>
                    <a:ext uri="{9D8B030D-6E8A-4147-A177-3AD203B41FA5}">
                      <a16:colId xmlns:a16="http://schemas.microsoft.com/office/drawing/2014/main" val="3583761510"/>
                    </a:ext>
                  </a:extLst>
                </a:gridCol>
                <a:gridCol w="1295740">
                  <a:extLst>
                    <a:ext uri="{9D8B030D-6E8A-4147-A177-3AD203B41FA5}">
                      <a16:colId xmlns:a16="http://schemas.microsoft.com/office/drawing/2014/main" val="3658820671"/>
                    </a:ext>
                  </a:extLst>
                </a:gridCol>
                <a:gridCol w="1027656">
                  <a:extLst>
                    <a:ext uri="{9D8B030D-6E8A-4147-A177-3AD203B41FA5}">
                      <a16:colId xmlns:a16="http://schemas.microsoft.com/office/drawing/2014/main" val="2108210623"/>
                    </a:ext>
                  </a:extLst>
                </a:gridCol>
                <a:gridCol w="714891">
                  <a:extLst>
                    <a:ext uri="{9D8B030D-6E8A-4147-A177-3AD203B41FA5}">
                      <a16:colId xmlns:a16="http://schemas.microsoft.com/office/drawing/2014/main" val="1893278977"/>
                    </a:ext>
                  </a:extLst>
                </a:gridCol>
              </a:tblGrid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Loading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koff(1/s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kon(1/Ms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KD(M)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Response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Loading Height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Association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Full R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621566304"/>
                  </a:ext>
                </a:extLst>
              </a:tr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DARA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30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40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9.86E-009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22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81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081075689"/>
                  </a:ext>
                </a:extLst>
              </a:tr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ISA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.52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61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8.35E-009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26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3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8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4223249587"/>
                  </a:ext>
                </a:extLst>
              </a:tr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4A8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59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95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9.48E-009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09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4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7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593173547"/>
                  </a:ext>
                </a:extLst>
              </a:tr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12C10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.37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97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7.71E-009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093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55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effectLst/>
                        </a:rPr>
                        <a:t>CD4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8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3965628883"/>
                  </a:ext>
                </a:extLst>
              </a:tr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26B4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.26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06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1.36E-008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9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1.0009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8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232632888"/>
                  </a:ext>
                </a:extLst>
              </a:tr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35G5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05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.98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8.67E-009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3132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64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78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330674771"/>
                  </a:ext>
                </a:extLst>
              </a:tr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5605-65A7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.99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.09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8.45E-009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2977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1.002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7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1293161775"/>
                  </a:ext>
                </a:extLst>
              </a:tr>
              <a:tr h="13232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IMM01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.99E-00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.18E+00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 dirty="0">
                          <a:solidFill>
                            <a:srgbClr val="FF0000"/>
                          </a:solidFill>
                          <a:effectLst/>
                        </a:rPr>
                        <a:t>1.20E-008</a:t>
                      </a:r>
                      <a:endParaRPr lang="en-US" sz="1100" b="0" i="0" u="none" strike="noStrike" dirty="0">
                        <a:solidFill>
                          <a:srgbClr val="FF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4826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>
                          <a:effectLst/>
                        </a:rPr>
                        <a:t>0.9659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CD4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100" u="none" strike="noStrike" dirty="0">
                          <a:effectLst/>
                        </a:rPr>
                        <a:t>0.992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296873755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554410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525</TotalTime>
  <Words>1322</Words>
  <Application>Microsoft Office PowerPoint</Application>
  <PresentationFormat>宽屏</PresentationFormat>
  <Paragraphs>449</Paragraphs>
  <Slides>10</Slides>
  <Notes>1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3</vt:i4>
      </vt:variant>
      <vt:variant>
        <vt:lpstr>幻灯片标题</vt:lpstr>
      </vt:variant>
      <vt:variant>
        <vt:i4>10</vt:i4>
      </vt:variant>
    </vt:vector>
  </HeadingPairs>
  <TitlesOfParts>
    <vt:vector size="19" baseType="lpstr">
      <vt:lpstr>等线</vt:lpstr>
      <vt:lpstr>等线 Light</vt:lpstr>
      <vt:lpstr>宋体</vt:lpstr>
      <vt:lpstr>Arial</vt:lpstr>
      <vt:lpstr>Times New Roman</vt:lpstr>
      <vt:lpstr>Office 主题​​</vt:lpstr>
      <vt:lpstr>Prism 10</vt:lpstr>
      <vt:lpstr>Prism 9</vt:lpstr>
      <vt:lpstr>GraphPad Prism Project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　松</dc:creator>
  <cp:lastModifiedBy>李　松</cp:lastModifiedBy>
  <cp:revision>160</cp:revision>
  <dcterms:created xsi:type="dcterms:W3CDTF">2023-09-24T15:21:41Z</dcterms:created>
  <dcterms:modified xsi:type="dcterms:W3CDTF">2024-04-08T10:09:09Z</dcterms:modified>
</cp:coreProperties>
</file>